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authors.xml" ContentType="application/vnd.ms-powerpoint.author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5" r:id="rId2"/>
    <p:sldId id="264" r:id="rId3"/>
    <p:sldId id="257" r:id="rId4"/>
  </p:sldIdLst>
  <p:sldSz cx="25199975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088BF4-3047-331D-79A7-2DC690836AC1}" name="Ilaria Laurenzana" initials="IL" userId="S::ilaria.laurenzana@crob.it::d20e3a4c-5152-4781-9a82-e8e358f0fc6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9933"/>
    <a:srgbClr val="FFFFFF"/>
    <a:srgbClr val="CC00CC"/>
    <a:srgbClr val="FF99CC"/>
    <a:srgbClr val="FFCCFF"/>
    <a:srgbClr val="FFCC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96468A-C539-4E7D-1B7F-3AD073F2ADF0}" v="1" dt="2025-01-27T09:50:41.670"/>
    <p1510:client id="{D64EE964-1AA1-1E8D-8A62-FF8CDAEA77E9}" v="8" dt="2025-01-27T09:10:08.52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>
        <p:scale>
          <a:sx n="10" d="100"/>
          <a:sy n="10" d="100"/>
        </p:scale>
        <p:origin x="-2484" y="-294"/>
      </p:cViewPr>
      <p:guideLst>
        <p:guide orient="horz" pos="11338"/>
        <p:guide pos="793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tonella Caivano" userId="S::antonella.caivano@crob.it::5513c8a0-81c4-4e80-a194-a4422c619f78" providerId="AD" clId="Web-{6034EF97-AB4E-75C1-B61A-61C390666007}"/>
    <pc:docChg chg="addSld delSld modSld">
      <pc:chgData name="Antonella Caivano" userId="S::antonella.caivano@crob.it::5513c8a0-81c4-4e80-a194-a4422c619f78" providerId="AD" clId="Web-{6034EF97-AB4E-75C1-B61A-61C390666007}" dt="2025-01-21T08:52:11.515" v="358" actId="20577"/>
      <pc:docMkLst>
        <pc:docMk/>
      </pc:docMkLst>
      <pc:sldChg chg="addSp modSp">
        <pc:chgData name="Antonella Caivano" userId="S::antonella.caivano@crob.it::5513c8a0-81c4-4e80-a194-a4422c619f78" providerId="AD" clId="Web-{6034EF97-AB4E-75C1-B61A-61C390666007}" dt="2025-01-21T07:29:48.421" v="82" actId="14100"/>
        <pc:sldMkLst>
          <pc:docMk/>
          <pc:sldMk cId="54607325" sldId="256"/>
        </pc:sldMkLst>
        <pc:spChg chg="add mod">
          <ac:chgData name="Antonella Caivano" userId="S::antonella.caivano@crob.it::5513c8a0-81c4-4e80-a194-a4422c619f78" providerId="AD" clId="Web-{6034EF97-AB4E-75C1-B61A-61C390666007}" dt="2025-01-21T07:29:20.779" v="77" actId="1076"/>
          <ac:spMkLst>
            <pc:docMk/>
            <pc:sldMk cId="54607325" sldId="256"/>
            <ac:spMk id="2" creationId="{35BC3299-3330-D11C-6379-F110ED812014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29:21.201" v="78" actId="1076"/>
          <ac:spMkLst>
            <pc:docMk/>
            <pc:sldMk cId="54607325" sldId="256"/>
            <ac:spMk id="5" creationId="{83D236C9-5DF3-1726-CC75-F4E12483C1EA}"/>
          </ac:spMkLst>
        </pc:spChg>
        <pc:spChg chg="add mod ord">
          <ac:chgData name="Antonella Caivano" userId="S::antonella.caivano@crob.it::5513c8a0-81c4-4e80-a194-a4422c619f78" providerId="AD" clId="Web-{6034EF97-AB4E-75C1-B61A-61C390666007}" dt="2025-01-21T07:29:00.028" v="76" actId="1076"/>
          <ac:spMkLst>
            <pc:docMk/>
            <pc:sldMk cId="54607325" sldId="256"/>
            <ac:spMk id="9" creationId="{BAAFD36C-D005-5593-5A9E-273080507380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28:59.606" v="75" actId="1076"/>
          <ac:spMkLst>
            <pc:docMk/>
            <pc:sldMk cId="54607325" sldId="256"/>
            <ac:spMk id="13" creationId="{41601F00-035F-1230-E75F-BFEDBB8A522C}"/>
          </ac:spMkLst>
        </pc:spChg>
        <pc:spChg chg="add mod ord">
          <ac:chgData name="Antonella Caivano" userId="S::antonella.caivano@crob.it::5513c8a0-81c4-4e80-a194-a4422c619f78" providerId="AD" clId="Web-{6034EF97-AB4E-75C1-B61A-61C390666007}" dt="2025-01-21T07:29:48.421" v="82" actId="14100"/>
          <ac:spMkLst>
            <pc:docMk/>
            <pc:sldMk cId="54607325" sldId="256"/>
            <ac:spMk id="14" creationId="{6805E781-2884-65B1-D274-18EACE290765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29:30.748" v="79" actId="14100"/>
          <ac:spMkLst>
            <pc:docMk/>
            <pc:sldMk cId="54607325" sldId="256"/>
            <ac:spMk id="15" creationId="{30D460F8-6DE2-6F3A-C89F-F09A62CAE86C}"/>
          </ac:spMkLst>
        </pc:spChg>
        <pc:grpChg chg="add">
          <ac:chgData name="Antonella Caivano" userId="S::antonella.caivano@crob.it::5513c8a0-81c4-4e80-a194-a4422c619f78" providerId="AD" clId="Web-{6034EF97-AB4E-75C1-B61A-61C390666007}" dt="2025-01-21T07:28:03.573" v="71"/>
          <ac:grpSpMkLst>
            <pc:docMk/>
            <pc:sldMk cId="54607325" sldId="256"/>
            <ac:grpSpMk id="16" creationId="{82ED57A8-E163-4C7C-4862-0F3EB2F8652C}"/>
          </ac:grpSpMkLst>
        </pc:grpChg>
        <pc:picChg chg="mod">
          <ac:chgData name="Antonella Caivano" userId="S::antonella.caivano@crob.it::5513c8a0-81c4-4e80-a194-a4422c619f78" providerId="AD" clId="Web-{6034EF97-AB4E-75C1-B61A-61C390666007}" dt="2025-01-21T07:24:31.175" v="57" actId="1076"/>
          <ac:picMkLst>
            <pc:docMk/>
            <pc:sldMk cId="54607325" sldId="256"/>
            <ac:picMk id="8" creationId="{3BA3FB26-183B-EEE9-D51A-4E269BE79FFC}"/>
          </ac:picMkLst>
        </pc:picChg>
      </pc:sldChg>
      <pc:sldChg chg="addSp modSp">
        <pc:chgData name="Antonella Caivano" userId="S::antonella.caivano@crob.it::5513c8a0-81c4-4e80-a194-a4422c619f78" providerId="AD" clId="Web-{6034EF97-AB4E-75C1-B61A-61C390666007}" dt="2025-01-21T07:48:14.118" v="232" actId="1076"/>
        <pc:sldMkLst>
          <pc:docMk/>
          <pc:sldMk cId="363783681" sldId="257"/>
        </pc:sldMkLst>
        <pc:spChg chg="add mod">
          <ac:chgData name="Antonella Caivano" userId="S::antonella.caivano@crob.it::5513c8a0-81c4-4e80-a194-a4422c619f78" providerId="AD" clId="Web-{6034EF97-AB4E-75C1-B61A-61C390666007}" dt="2025-01-21T07:41:07.711" v="187" actId="14100"/>
          <ac:spMkLst>
            <pc:docMk/>
            <pc:sldMk cId="363783681" sldId="257"/>
            <ac:spMk id="7" creationId="{5FEDF361-938B-AE92-9E87-4330BB57AFFA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41:13.587" v="189" actId="1076"/>
          <ac:spMkLst>
            <pc:docMk/>
            <pc:sldMk cId="363783681" sldId="257"/>
            <ac:spMk id="8" creationId="{530400C8-D61C-772E-5DB8-25A01453B81D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48:14.118" v="232" actId="1076"/>
          <ac:spMkLst>
            <pc:docMk/>
            <pc:sldMk cId="363783681" sldId="257"/>
            <ac:spMk id="10" creationId="{93C14AC9-FF6D-B1EE-5254-354BF712461F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42:29.511" v="196" actId="1076"/>
          <ac:spMkLst>
            <pc:docMk/>
            <pc:sldMk cId="363783681" sldId="257"/>
            <ac:spMk id="11" creationId="{FD28A142-4474-33D0-A81D-DB0F03F33E15}"/>
          </ac:spMkLst>
        </pc:spChg>
        <pc:picChg chg="mod">
          <ac:chgData name="Antonella Caivano" userId="S::antonella.caivano@crob.it::5513c8a0-81c4-4e80-a194-a4422c619f78" providerId="AD" clId="Web-{6034EF97-AB4E-75C1-B61A-61C390666007}" dt="2025-01-21T07:43:11.575" v="204" actId="1076"/>
          <ac:picMkLst>
            <pc:docMk/>
            <pc:sldMk cId="363783681" sldId="257"/>
            <ac:picMk id="3" creationId="{A0D5ACAD-6FD7-0341-1703-0CD28BE78279}"/>
          </ac:picMkLst>
        </pc:picChg>
        <pc:picChg chg="mod modCrop">
          <ac:chgData name="Antonella Caivano" userId="S::antonella.caivano@crob.it::5513c8a0-81c4-4e80-a194-a4422c619f78" providerId="AD" clId="Web-{6034EF97-AB4E-75C1-B61A-61C390666007}" dt="2025-01-21T07:43:06.247" v="203" actId="1076"/>
          <ac:picMkLst>
            <pc:docMk/>
            <pc:sldMk cId="363783681" sldId="257"/>
            <ac:picMk id="4" creationId="{1E4250FD-7998-9A47-89AF-BEB2933CE524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43:22.388" v="205" actId="1076"/>
          <ac:picMkLst>
            <pc:docMk/>
            <pc:sldMk cId="363783681" sldId="257"/>
            <ac:picMk id="13" creationId="{6431EF51-C4F2-9F07-85C8-76FA71CA375C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40:44.632" v="184" actId="1076"/>
          <ac:picMkLst>
            <pc:docMk/>
            <pc:sldMk cId="363783681" sldId="257"/>
            <ac:picMk id="1026" creationId="{539EE3CA-BB9F-1354-162A-85F5EA0567CE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40:33.898" v="182" actId="14100"/>
          <ac:picMkLst>
            <pc:docMk/>
            <pc:sldMk cId="363783681" sldId="257"/>
            <ac:picMk id="1027" creationId="{8064DBFE-CD9E-79D1-16F8-09D5696AFD26}"/>
          </ac:picMkLst>
        </pc:picChg>
      </pc:sldChg>
      <pc:sldChg chg="addSp modSp">
        <pc:chgData name="Antonella Caivano" userId="S::antonella.caivano@crob.it::5513c8a0-81c4-4e80-a194-a4422c619f78" providerId="AD" clId="Web-{6034EF97-AB4E-75C1-B61A-61C390666007}" dt="2025-01-21T07:51:38.875" v="306" actId="20577"/>
        <pc:sldMkLst>
          <pc:docMk/>
          <pc:sldMk cId="3041777217" sldId="259"/>
        </pc:sldMkLst>
        <pc:spChg chg="add mod">
          <ac:chgData name="Antonella Caivano" userId="S::antonella.caivano@crob.it::5513c8a0-81c4-4e80-a194-a4422c619f78" providerId="AD" clId="Web-{6034EF97-AB4E-75C1-B61A-61C390666007}" dt="2025-01-21T07:46:22.738" v="221" actId="1076"/>
          <ac:spMkLst>
            <pc:docMk/>
            <pc:sldMk cId="3041777217" sldId="259"/>
            <ac:spMk id="10" creationId="{C3A0FBB7-3BB2-6251-8263-2B21D6CDFCF2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47:10.928" v="229" actId="1076"/>
          <ac:spMkLst>
            <pc:docMk/>
            <pc:sldMk cId="3041777217" sldId="259"/>
            <ac:spMk id="14" creationId="{DE955119-F561-5070-E7FA-B98341E15066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51:38.875" v="306" actId="20577"/>
          <ac:spMkLst>
            <pc:docMk/>
            <pc:sldMk cId="3041777217" sldId="259"/>
            <ac:spMk id="24" creationId="{29DA8602-7783-458A-A099-477A73DDC2D3}"/>
          </ac:spMkLst>
        </pc:spChg>
      </pc:sldChg>
      <pc:sldChg chg="addSp modSp">
        <pc:chgData name="Antonella Caivano" userId="S::antonella.caivano@crob.it::5513c8a0-81c4-4e80-a194-a4422c619f78" providerId="AD" clId="Web-{6034EF97-AB4E-75C1-B61A-61C390666007}" dt="2025-01-21T07:48:06.602" v="231" actId="1076"/>
        <pc:sldMkLst>
          <pc:docMk/>
          <pc:sldMk cId="639010659" sldId="264"/>
        </pc:sldMkLst>
        <pc:spChg chg="mod">
          <ac:chgData name="Antonella Caivano" userId="S::antonella.caivano@crob.it::5513c8a0-81c4-4e80-a194-a4422c619f78" providerId="AD" clId="Web-{6034EF97-AB4E-75C1-B61A-61C390666007}" dt="2025-01-21T07:48:06.602" v="231" actId="1076"/>
          <ac:spMkLst>
            <pc:docMk/>
            <pc:sldMk cId="639010659" sldId="264"/>
            <ac:spMk id="4" creationId="{90FF9E3A-8F8F-9531-CD82-2DB3BFD08EA3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42:13.073" v="194" actId="1076"/>
          <ac:spMkLst>
            <pc:docMk/>
            <pc:sldMk cId="639010659" sldId="264"/>
            <ac:spMk id="8" creationId="{1840584E-E6C5-8920-089E-AA58592394C4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42:18.948" v="195" actId="1076"/>
          <ac:spMkLst>
            <pc:docMk/>
            <pc:sldMk cId="639010659" sldId="264"/>
            <ac:spMk id="9" creationId="{A6A2E30F-3505-B965-2826-EE8772335677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40:01.975" v="177" actId="1076"/>
          <ac:spMkLst>
            <pc:docMk/>
            <pc:sldMk cId="639010659" sldId="264"/>
            <ac:spMk id="10" creationId="{FCF0A08A-4C29-126A-9A76-DA6A8C180103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39:50.943" v="175" actId="1076"/>
          <ac:spMkLst>
            <pc:docMk/>
            <pc:sldMk cId="639010659" sldId="264"/>
            <ac:spMk id="11" creationId="{E5CF7DFD-E264-B178-C79A-AE1F06075F88}"/>
          </ac:spMkLst>
        </pc:spChg>
        <pc:picChg chg="mod">
          <ac:chgData name="Antonella Caivano" userId="S::antonella.caivano@crob.it::5513c8a0-81c4-4e80-a194-a4422c619f78" providerId="AD" clId="Web-{6034EF97-AB4E-75C1-B61A-61C390666007}" dt="2025-01-21T07:39:34.005" v="172" actId="1076"/>
          <ac:picMkLst>
            <pc:docMk/>
            <pc:sldMk cId="639010659" sldId="264"/>
            <ac:picMk id="6" creationId="{FFD0AA9A-B3F1-8335-57C4-8CC07FB81C98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39:33.989" v="171" actId="1076"/>
          <ac:picMkLst>
            <pc:docMk/>
            <pc:sldMk cId="639010659" sldId="264"/>
            <ac:picMk id="7" creationId="{7CF99E4A-4DAF-9031-C4C4-61A6D17D6185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39:16.160" v="167" actId="1076"/>
          <ac:picMkLst>
            <pc:docMk/>
            <pc:sldMk cId="639010659" sldId="264"/>
            <ac:picMk id="3074" creationId="{99DFA977-70AC-6E3A-F875-7193024AE895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39:06.691" v="165" actId="14100"/>
          <ac:picMkLst>
            <pc:docMk/>
            <pc:sldMk cId="639010659" sldId="264"/>
            <ac:picMk id="3075" creationId="{27EFFD25-9982-0011-4684-7EB54518CD39}"/>
          </ac:picMkLst>
        </pc:picChg>
      </pc:sldChg>
      <pc:sldChg chg="addSp delSp modSp">
        <pc:chgData name="Antonella Caivano" userId="S::antonella.caivano@crob.it::5513c8a0-81c4-4e80-a194-a4422c619f78" providerId="AD" clId="Web-{6034EF97-AB4E-75C1-B61A-61C390666007}" dt="2025-01-21T08:52:11.515" v="358" actId="20577"/>
        <pc:sldMkLst>
          <pc:docMk/>
          <pc:sldMk cId="2716383154" sldId="265"/>
        </pc:sldMkLst>
        <pc:spChg chg="mod">
          <ac:chgData name="Antonella Caivano" userId="S::antonella.caivano@crob.it::5513c8a0-81c4-4e80-a194-a4422c619f78" providerId="AD" clId="Web-{6034EF97-AB4E-75C1-B61A-61C390666007}" dt="2025-01-21T07:47:56.851" v="230" actId="1076"/>
          <ac:spMkLst>
            <pc:docMk/>
            <pc:sldMk cId="2716383154" sldId="265"/>
            <ac:spMk id="4" creationId="{2125FE04-5FDE-E47C-C0FE-DB8F5E2430A6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35:26.121" v="117" actId="1076"/>
          <ac:spMkLst>
            <pc:docMk/>
            <pc:sldMk cId="2716383154" sldId="265"/>
            <ac:spMk id="5" creationId="{B57388DB-985E-9E80-D430-3BA5CBCA378E}"/>
          </ac:spMkLst>
        </pc:spChg>
        <pc:spChg chg="mod">
          <ac:chgData name="Antonella Caivano" userId="S::antonella.caivano@crob.it::5513c8a0-81c4-4e80-a194-a4422c619f78" providerId="AD" clId="Web-{6034EF97-AB4E-75C1-B61A-61C390666007}" dt="2025-01-21T07:35:18.089" v="116" actId="1076"/>
          <ac:spMkLst>
            <pc:docMk/>
            <pc:sldMk cId="2716383154" sldId="265"/>
            <ac:spMk id="6" creationId="{B424E747-1BBD-13A1-A57C-6454F1F10D6B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38:32.034" v="163" actId="1076"/>
          <ac:spMkLst>
            <pc:docMk/>
            <pc:sldMk cId="2716383154" sldId="265"/>
            <ac:spMk id="8" creationId="{C4069A0F-9F3F-4326-4BD2-939BFEB36017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7:38:23.768" v="162" actId="1076"/>
          <ac:spMkLst>
            <pc:docMk/>
            <pc:sldMk cId="2716383154" sldId="265"/>
            <ac:spMk id="9" creationId="{5F95435A-6331-603E-2A50-9816C4D9A279}"/>
          </ac:spMkLst>
        </pc:spChg>
        <pc:spChg chg="add mod">
          <ac:chgData name="Antonella Caivano" userId="S::antonella.caivano@crob.it::5513c8a0-81c4-4e80-a194-a4422c619f78" providerId="AD" clId="Web-{6034EF97-AB4E-75C1-B61A-61C390666007}" dt="2025-01-21T08:52:11.515" v="358" actId="20577"/>
          <ac:spMkLst>
            <pc:docMk/>
            <pc:sldMk cId="2716383154" sldId="265"/>
            <ac:spMk id="10" creationId="{430B456F-BDF4-C7FE-040C-D98D70C4FCDE}"/>
          </ac:spMkLst>
        </pc:spChg>
        <pc:picChg chg="add del">
          <ac:chgData name="Antonella Caivano" userId="S::antonella.caivano@crob.it::5513c8a0-81c4-4e80-a194-a4422c619f78" providerId="AD" clId="Web-{6034EF97-AB4E-75C1-B61A-61C390666007}" dt="2025-01-21T07:31:57.691" v="94"/>
          <ac:picMkLst>
            <pc:docMk/>
            <pc:sldMk cId="2716383154" sldId="265"/>
            <ac:picMk id="26" creationId="{CFE2D9FD-E8B4-EF0F-BCE3-A56EFAAEFA42}"/>
          </ac:picMkLst>
        </pc:picChg>
        <pc:picChg chg="add del mod">
          <ac:chgData name="Antonella Caivano" userId="S::antonella.caivano@crob.it::5513c8a0-81c4-4e80-a194-a4422c619f78" providerId="AD" clId="Web-{6034EF97-AB4E-75C1-B61A-61C390666007}" dt="2025-01-21T07:42:01.432" v="192" actId="1076"/>
          <ac:picMkLst>
            <pc:docMk/>
            <pc:sldMk cId="2716383154" sldId="265"/>
            <ac:picMk id="28" creationId="{38C82605-F25E-456E-73F0-4159E0059876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42:01.432" v="193" actId="1076"/>
          <ac:picMkLst>
            <pc:docMk/>
            <pc:sldMk cId="2716383154" sldId="265"/>
            <ac:picMk id="29" creationId="{C8FC3826-6F4F-9B49-5FDB-05A8C09DC585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34:50.619" v="112" actId="14100"/>
          <ac:picMkLst>
            <pc:docMk/>
            <pc:sldMk cId="2716383154" sldId="265"/>
            <ac:picMk id="2054" creationId="{20467BE2-F9E1-D219-A5BC-09701D1963EA}"/>
          </ac:picMkLst>
        </pc:picChg>
        <pc:picChg chg="mod">
          <ac:chgData name="Antonella Caivano" userId="S::antonella.caivano@crob.it::5513c8a0-81c4-4e80-a194-a4422c619f78" providerId="AD" clId="Web-{6034EF97-AB4E-75C1-B61A-61C390666007}" dt="2025-01-21T07:35:00.463" v="115" actId="1076"/>
          <ac:picMkLst>
            <pc:docMk/>
            <pc:sldMk cId="2716383154" sldId="265"/>
            <ac:picMk id="2055" creationId="{E20A3218-22FD-09DC-9D72-567C88AE2E0D}"/>
          </ac:picMkLst>
        </pc:picChg>
        <pc:cxnChg chg="add mod">
          <ac:chgData name="Antonella Caivano" userId="S::antonella.caivano@crob.it::5513c8a0-81c4-4e80-a194-a4422c619f78" providerId="AD" clId="Web-{6034EF97-AB4E-75C1-B61A-61C390666007}" dt="2025-01-21T07:32:50.490" v="97" actId="14100"/>
          <ac:cxnSpMkLst>
            <pc:docMk/>
            <pc:sldMk cId="2716383154" sldId="265"/>
            <ac:cxnSpMk id="2" creationId="{78DC44B0-9567-FBE7-E5B6-8C69211DE9AD}"/>
          </ac:cxnSpMkLst>
        </pc:cxnChg>
        <pc:cxnChg chg="add mod">
          <ac:chgData name="Antonella Caivano" userId="S::antonella.caivano@crob.it::5513c8a0-81c4-4e80-a194-a4422c619f78" providerId="AD" clId="Web-{6034EF97-AB4E-75C1-B61A-61C390666007}" dt="2025-01-21T07:31:44.128" v="92"/>
          <ac:cxnSpMkLst>
            <pc:docMk/>
            <pc:sldMk cId="2716383154" sldId="265"/>
            <ac:cxnSpMk id="7" creationId="{B5A4969A-6DCD-CFC7-9E57-BFF192073FEB}"/>
          </ac:cxnSpMkLst>
        </pc:cxnChg>
      </pc:sldChg>
      <pc:sldChg chg="addSp delSp modSp add del replId">
        <pc:chgData name="Antonella Caivano" userId="S::antonella.caivano@crob.it::5513c8a0-81c4-4e80-a194-a4422c619f78" providerId="AD" clId="Web-{6034EF97-AB4E-75C1-B61A-61C390666007}" dt="2025-01-21T07:47:00.427" v="227"/>
        <pc:sldMkLst>
          <pc:docMk/>
          <pc:sldMk cId="860782887" sldId="266"/>
        </pc:sldMkLst>
        <pc:spChg chg="add del mod">
          <ac:chgData name="Antonella Caivano" userId="S::antonella.caivano@crob.it::5513c8a0-81c4-4e80-a194-a4422c619f78" providerId="AD" clId="Web-{6034EF97-AB4E-75C1-B61A-61C390666007}" dt="2025-01-21T07:46:54.740" v="226"/>
          <ac:spMkLst>
            <pc:docMk/>
            <pc:sldMk cId="860782887" sldId="266"/>
            <ac:spMk id="14" creationId="{F2B19F29-9A0F-949A-EE5E-AF9F3408007D}"/>
          </ac:spMkLst>
        </pc:spChg>
      </pc:sldChg>
    </pc:docChg>
  </pc:docChgLst>
  <pc:docChgLst>
    <pc:chgData name="Luciana De Luca" userId="S::luciana.deluca@crob.it::bae8d283-e187-4b8e-966b-081af72c9cd4" providerId="AD" clId="Web-{FFBDAC87-E26B-6492-6790-CF80EF7DE3AA}"/>
    <pc:docChg chg="modSld">
      <pc:chgData name="Luciana De Luca" userId="S::luciana.deluca@crob.it::bae8d283-e187-4b8e-966b-081af72c9cd4" providerId="AD" clId="Web-{FFBDAC87-E26B-6492-6790-CF80EF7DE3AA}" dt="2025-01-17T07:59:50.281" v="29" actId="1076"/>
      <pc:docMkLst>
        <pc:docMk/>
      </pc:docMkLst>
      <pc:sldChg chg="modSp">
        <pc:chgData name="Luciana De Luca" userId="S::luciana.deluca@crob.it::bae8d283-e187-4b8e-966b-081af72c9cd4" providerId="AD" clId="Web-{FFBDAC87-E26B-6492-6790-CF80EF7DE3AA}" dt="2025-01-17T07:59:50.281" v="29" actId="1076"/>
        <pc:sldMkLst>
          <pc:docMk/>
          <pc:sldMk cId="3041777217" sldId="259"/>
        </pc:sldMkLst>
        <pc:spChg chg="mod">
          <ac:chgData name="Luciana De Luca" userId="S::luciana.deluca@crob.it::bae8d283-e187-4b8e-966b-081af72c9cd4" providerId="AD" clId="Web-{FFBDAC87-E26B-6492-6790-CF80EF7DE3AA}" dt="2025-01-17T07:59:29.046" v="21"/>
          <ac:spMkLst>
            <pc:docMk/>
            <pc:sldMk cId="3041777217" sldId="259"/>
            <ac:spMk id="18" creationId="{D1650DBB-F4FA-B2DC-2D58-A64A6289F73B}"/>
          </ac:spMkLst>
        </pc:spChg>
        <pc:spChg chg="mod">
          <ac:chgData name="Luciana De Luca" userId="S::luciana.deluca@crob.it::bae8d283-e187-4b8e-966b-081af72c9cd4" providerId="AD" clId="Web-{FFBDAC87-E26B-6492-6790-CF80EF7DE3AA}" dt="2025-01-17T07:59:29.046" v="22"/>
          <ac:spMkLst>
            <pc:docMk/>
            <pc:sldMk cId="3041777217" sldId="259"/>
            <ac:spMk id="19" creationId="{87C08781-3A6E-1D74-5923-26B0BCCA7AB0}"/>
          </ac:spMkLst>
        </pc:spChg>
        <pc:spChg chg="mod">
          <ac:chgData name="Luciana De Luca" userId="S::luciana.deluca@crob.it::bae8d283-e187-4b8e-966b-081af72c9cd4" providerId="AD" clId="Web-{FFBDAC87-E26B-6492-6790-CF80EF7DE3AA}" dt="2025-01-17T07:59:29.046" v="23"/>
          <ac:spMkLst>
            <pc:docMk/>
            <pc:sldMk cId="3041777217" sldId="259"/>
            <ac:spMk id="21" creationId="{63950A08-EAFA-C811-516F-E22B7E7EB193}"/>
          </ac:spMkLst>
        </pc:spChg>
        <pc:spChg chg="mod">
          <ac:chgData name="Luciana De Luca" userId="S::luciana.deluca@crob.it::bae8d283-e187-4b8e-966b-081af72c9cd4" providerId="AD" clId="Web-{FFBDAC87-E26B-6492-6790-CF80EF7DE3AA}" dt="2025-01-17T07:59:50.266" v="27" actId="1076"/>
          <ac:spMkLst>
            <pc:docMk/>
            <pc:sldMk cId="3041777217" sldId="259"/>
            <ac:spMk id="22" creationId="{45B75973-7598-B212-443C-B7316234E6A8}"/>
          </ac:spMkLst>
        </pc:spChg>
        <pc:spChg chg="mod">
          <ac:chgData name="Luciana De Luca" userId="S::luciana.deluca@crob.it::bae8d283-e187-4b8e-966b-081af72c9cd4" providerId="AD" clId="Web-{FFBDAC87-E26B-6492-6790-CF80EF7DE3AA}" dt="2025-01-17T07:59:50.266" v="28" actId="1076"/>
          <ac:spMkLst>
            <pc:docMk/>
            <pc:sldMk cId="3041777217" sldId="259"/>
            <ac:spMk id="23" creationId="{98C4C43B-2616-97A3-268C-4D129322F49B}"/>
          </ac:spMkLst>
        </pc:spChg>
        <pc:spChg chg="mod">
          <ac:chgData name="Luciana De Luca" userId="S::luciana.deluca@crob.it::bae8d283-e187-4b8e-966b-081af72c9cd4" providerId="AD" clId="Web-{FFBDAC87-E26B-6492-6790-CF80EF7DE3AA}" dt="2025-01-17T07:59:50.281" v="29" actId="1076"/>
          <ac:spMkLst>
            <pc:docMk/>
            <pc:sldMk cId="3041777217" sldId="259"/>
            <ac:spMk id="25" creationId="{9285FD73-229E-5B8D-0B36-B9D6A2FA9609}"/>
          </ac:spMkLst>
        </pc:spChg>
      </pc:sldChg>
    </pc:docChg>
  </pc:docChgLst>
  <pc:docChgLst>
    <pc:chgData name="Luciana De Luca" userId="S::luciana.deluca@crob.it::bae8d283-e187-4b8e-966b-081af72c9cd4" providerId="AD" clId="Web-{2396468A-C539-4E7D-1B7F-3AD073F2ADF0}"/>
    <pc:docChg chg="modSld">
      <pc:chgData name="Luciana De Luca" userId="S::luciana.deluca@crob.it::bae8d283-e187-4b8e-966b-081af72c9cd4" providerId="AD" clId="Web-{2396468A-C539-4E7D-1B7F-3AD073F2ADF0}" dt="2025-01-27T09:50:41.670" v="0" actId="1076"/>
      <pc:docMkLst>
        <pc:docMk/>
      </pc:docMkLst>
      <pc:sldChg chg="modSp">
        <pc:chgData name="Luciana De Luca" userId="S::luciana.deluca@crob.it::bae8d283-e187-4b8e-966b-081af72c9cd4" providerId="AD" clId="Web-{2396468A-C539-4E7D-1B7F-3AD073F2ADF0}" dt="2025-01-27T09:50:41.670" v="0" actId="1076"/>
        <pc:sldMkLst>
          <pc:docMk/>
          <pc:sldMk cId="54607325" sldId="256"/>
        </pc:sldMkLst>
        <pc:picChg chg="mod">
          <ac:chgData name="Luciana De Luca" userId="S::luciana.deluca@crob.it::bae8d283-e187-4b8e-966b-081af72c9cd4" providerId="AD" clId="Web-{2396468A-C539-4E7D-1B7F-3AD073F2ADF0}" dt="2025-01-27T09:50:41.670" v="0" actId="1076"/>
          <ac:picMkLst>
            <pc:docMk/>
            <pc:sldMk cId="54607325" sldId="256"/>
            <ac:picMk id="18" creationId="{FD0845AF-1684-4892-1E4F-93626352F7C3}"/>
          </ac:picMkLst>
        </pc:picChg>
      </pc:sldChg>
    </pc:docChg>
  </pc:docChgLst>
  <pc:docChgLst>
    <pc:chgData name="Luciana De Luca" userId="S::luciana.deluca@crob.it::bae8d283-e187-4b8e-966b-081af72c9cd4" providerId="AD" clId="Web-{1EDD24A3-F452-EEA6-50A0-3E32301D4543}"/>
    <pc:docChg chg="modSld">
      <pc:chgData name="Luciana De Luca" userId="S::luciana.deluca@crob.it::bae8d283-e187-4b8e-966b-081af72c9cd4" providerId="AD" clId="Web-{1EDD24A3-F452-EEA6-50A0-3E32301D4543}" dt="2025-01-20T09:40:47.771" v="20" actId="1076"/>
      <pc:docMkLst>
        <pc:docMk/>
      </pc:docMkLst>
      <pc:sldChg chg="addSp delSp modSp">
        <pc:chgData name="Luciana De Luca" userId="S::luciana.deluca@crob.it::bae8d283-e187-4b8e-966b-081af72c9cd4" providerId="AD" clId="Web-{1EDD24A3-F452-EEA6-50A0-3E32301D4543}" dt="2025-01-20T09:40:47.771" v="20" actId="1076"/>
        <pc:sldMkLst>
          <pc:docMk/>
          <pc:sldMk cId="54607325" sldId="256"/>
        </pc:sldMkLst>
        <pc:spChg chg="add del mod">
          <ac:chgData name="Luciana De Luca" userId="S::luciana.deluca@crob.it::bae8d283-e187-4b8e-966b-081af72c9cd4" providerId="AD" clId="Web-{1EDD24A3-F452-EEA6-50A0-3E32301D4543}" dt="2025-01-20T09:38:29.188" v="3"/>
          <ac:spMkLst>
            <pc:docMk/>
            <pc:sldMk cId="54607325" sldId="256"/>
            <ac:spMk id="2" creationId="{916ECE0B-08EB-EE24-F656-89C980E9FADD}"/>
          </ac:spMkLst>
        </pc:spChg>
        <pc:spChg chg="mod">
          <ac:chgData name="Luciana De Luca" userId="S::luciana.deluca@crob.it::bae8d283-e187-4b8e-966b-081af72c9cd4" providerId="AD" clId="Web-{1EDD24A3-F452-EEA6-50A0-3E32301D4543}" dt="2025-01-20T09:40:42.162" v="17" actId="1076"/>
          <ac:spMkLst>
            <pc:docMk/>
            <pc:sldMk cId="54607325" sldId="256"/>
            <ac:spMk id="4" creationId="{3C0A09C8-F654-94DD-0DE0-9E3DC579C252}"/>
          </ac:spMkLst>
        </pc:spChg>
        <pc:spChg chg="add mod">
          <ac:chgData name="Luciana De Luca" userId="S::luciana.deluca@crob.it::bae8d283-e187-4b8e-966b-081af72c9cd4" providerId="AD" clId="Web-{1EDD24A3-F452-EEA6-50A0-3E32301D4543}" dt="2025-01-20T09:40:42.162" v="18" actId="1076"/>
          <ac:spMkLst>
            <pc:docMk/>
            <pc:sldMk cId="54607325" sldId="256"/>
            <ac:spMk id="9" creationId="{672C801C-0498-22E6-17DF-550A24647C06}"/>
          </ac:spMkLst>
        </pc:spChg>
        <pc:picChg chg="del">
          <ac:chgData name="Luciana De Luca" userId="S::luciana.deluca@crob.it::bae8d283-e187-4b8e-966b-081af72c9cd4" providerId="AD" clId="Web-{1EDD24A3-F452-EEA6-50A0-3E32301D4543}" dt="2025-01-20T09:38:18.969" v="0"/>
          <ac:picMkLst>
            <pc:docMk/>
            <pc:sldMk cId="54607325" sldId="256"/>
            <ac:picMk id="5" creationId="{01F9D5D4-E789-924E-265B-9454046C806C}"/>
          </ac:picMkLst>
        </pc:picChg>
        <pc:picChg chg="add del mod modCrop">
          <ac:chgData name="Luciana De Luca" userId="S::luciana.deluca@crob.it::bae8d283-e187-4b8e-966b-081af72c9cd4" providerId="AD" clId="Web-{1EDD24A3-F452-EEA6-50A0-3E32301D4543}" dt="2025-01-20T09:39:34.769" v="8"/>
          <ac:picMkLst>
            <pc:docMk/>
            <pc:sldMk cId="54607325" sldId="256"/>
            <ac:picMk id="7" creationId="{735E6B00-9272-2248-F6A6-A0529729B48B}"/>
          </ac:picMkLst>
        </pc:picChg>
        <pc:picChg chg="mod">
          <ac:chgData name="Luciana De Luca" userId="S::luciana.deluca@crob.it::bae8d283-e187-4b8e-966b-081af72c9cd4" providerId="AD" clId="Web-{1EDD24A3-F452-EEA6-50A0-3E32301D4543}" dt="2025-01-20T09:40:42.146" v="16" actId="1076"/>
          <ac:picMkLst>
            <pc:docMk/>
            <pc:sldMk cId="54607325" sldId="256"/>
            <ac:picMk id="8" creationId="{3BA3FB26-183B-EEE9-D51A-4E269BE79FFC}"/>
          </ac:picMkLst>
        </pc:picChg>
        <pc:picChg chg="add mod">
          <ac:chgData name="Luciana De Luca" userId="S::luciana.deluca@crob.it::bae8d283-e187-4b8e-966b-081af72c9cd4" providerId="AD" clId="Web-{1EDD24A3-F452-EEA6-50A0-3E32301D4543}" dt="2025-01-20T09:40:47.771" v="20" actId="1076"/>
          <ac:picMkLst>
            <pc:docMk/>
            <pc:sldMk cId="54607325" sldId="256"/>
            <ac:picMk id="10" creationId="{B5A2D91D-B6D3-DFD1-7B76-5BC767808B5E}"/>
          </ac:picMkLst>
        </pc:picChg>
      </pc:sldChg>
    </pc:docChg>
  </pc:docChgLst>
  <pc:docChgLst>
    <pc:chgData name="Antonella Caivano" userId="S::antonella.caivano@crob.it::5513c8a0-81c4-4e80-a194-a4422c619f78" providerId="AD" clId="Web-{D64EE964-1AA1-1E8D-8A62-FF8CDAEA77E9}"/>
    <pc:docChg chg="modSld">
      <pc:chgData name="Antonella Caivano" userId="S::antonella.caivano@crob.it::5513c8a0-81c4-4e80-a194-a4422c619f78" providerId="AD" clId="Web-{D64EE964-1AA1-1E8D-8A62-FF8CDAEA77E9}" dt="2025-01-27T09:10:08.526" v="7" actId="1076"/>
      <pc:docMkLst>
        <pc:docMk/>
      </pc:docMkLst>
      <pc:sldChg chg="modSp">
        <pc:chgData name="Antonella Caivano" userId="S::antonella.caivano@crob.it::5513c8a0-81c4-4e80-a194-a4422c619f78" providerId="AD" clId="Web-{D64EE964-1AA1-1E8D-8A62-FF8CDAEA77E9}" dt="2025-01-27T09:10:08.526" v="7" actId="1076"/>
        <pc:sldMkLst>
          <pc:docMk/>
          <pc:sldMk cId="54607325" sldId="256"/>
        </pc:sldMkLst>
        <pc:spChg chg="mod">
          <ac:chgData name="Antonella Caivano" userId="S::antonella.caivano@crob.it::5513c8a0-81c4-4e80-a194-a4422c619f78" providerId="AD" clId="Web-{D64EE964-1AA1-1E8D-8A62-FF8CDAEA77E9}" dt="2025-01-27T09:09:21.728" v="0" actId="1076"/>
          <ac:spMkLst>
            <pc:docMk/>
            <pc:sldMk cId="54607325" sldId="256"/>
            <ac:spMk id="3" creationId="{21B078B1-FEED-C6E2-9E5A-D94016EAD6B0}"/>
          </ac:spMkLst>
        </pc:spChg>
        <pc:spChg chg="mod">
          <ac:chgData name="Antonella Caivano" userId="S::antonella.caivano@crob.it::5513c8a0-81c4-4e80-a194-a4422c619f78" providerId="AD" clId="Web-{D64EE964-1AA1-1E8D-8A62-FF8CDAEA77E9}" dt="2025-01-27T09:09:21.791" v="2" actId="1076"/>
          <ac:spMkLst>
            <pc:docMk/>
            <pc:sldMk cId="54607325" sldId="256"/>
            <ac:spMk id="4" creationId="{3C0A09C8-F654-94DD-0DE0-9E3DC579C252}"/>
          </ac:spMkLst>
        </pc:spChg>
        <pc:spChg chg="mod">
          <ac:chgData name="Antonella Caivano" userId="S::antonella.caivano@crob.it::5513c8a0-81c4-4e80-a194-a4422c619f78" providerId="AD" clId="Web-{D64EE964-1AA1-1E8D-8A62-FF8CDAEA77E9}" dt="2025-01-27T09:10:08.526" v="7" actId="1076"/>
          <ac:spMkLst>
            <pc:docMk/>
            <pc:sldMk cId="54607325" sldId="256"/>
            <ac:spMk id="14" creationId="{6805E781-2884-65B1-D274-18EACE290765}"/>
          </ac:spMkLst>
        </pc:spChg>
        <pc:spChg chg="mod">
          <ac:chgData name="Antonella Caivano" userId="S::antonella.caivano@crob.it::5513c8a0-81c4-4e80-a194-a4422c619f78" providerId="AD" clId="Web-{D64EE964-1AA1-1E8D-8A62-FF8CDAEA77E9}" dt="2025-01-27T09:09:21.853" v="4" actId="1076"/>
          <ac:spMkLst>
            <pc:docMk/>
            <pc:sldMk cId="54607325" sldId="256"/>
            <ac:spMk id="22" creationId="{B92C5C4C-4F39-462C-EB6C-527AC3856ABE}"/>
          </ac:spMkLst>
        </pc:spChg>
        <pc:grpChg chg="mod">
          <ac:chgData name="Antonella Caivano" userId="S::antonella.caivano@crob.it::5513c8a0-81c4-4e80-a194-a4422c619f78" providerId="AD" clId="Web-{D64EE964-1AA1-1E8D-8A62-FF8CDAEA77E9}" dt="2025-01-27T09:09:22.213" v="5" actId="1076"/>
          <ac:grpSpMkLst>
            <pc:docMk/>
            <pc:sldMk cId="54607325" sldId="256"/>
            <ac:grpSpMk id="25" creationId="{7444C4B0-CEDB-6412-65BE-DD65F5FD57A7}"/>
          </ac:grpSpMkLst>
        </pc:grpChg>
        <pc:picChg chg="mod">
          <ac:chgData name="Antonella Caivano" userId="S::antonella.caivano@crob.it::5513c8a0-81c4-4e80-a194-a4422c619f78" providerId="AD" clId="Web-{D64EE964-1AA1-1E8D-8A62-FF8CDAEA77E9}" dt="2025-01-27T09:09:21.775" v="1" actId="1076"/>
          <ac:picMkLst>
            <pc:docMk/>
            <pc:sldMk cId="54607325" sldId="256"/>
            <ac:picMk id="10" creationId="{B5A2D91D-B6D3-DFD1-7B76-5BC767808B5E}"/>
          </ac:picMkLst>
        </pc:picChg>
        <pc:picChg chg="mod">
          <ac:chgData name="Antonella Caivano" userId="S::antonella.caivano@crob.it::5513c8a0-81c4-4e80-a194-a4422c619f78" providerId="AD" clId="Web-{D64EE964-1AA1-1E8D-8A62-FF8CDAEA77E9}" dt="2025-01-27T09:09:21.822" v="3" actId="1076"/>
          <ac:picMkLst>
            <pc:docMk/>
            <pc:sldMk cId="54607325" sldId="256"/>
            <ac:picMk id="18" creationId="{FD0845AF-1684-4892-1E4F-93626352F7C3}"/>
          </ac:picMkLst>
        </pc:picChg>
      </pc:sldChg>
    </pc:docChg>
  </pc:docChgLst>
  <pc:docChgLst>
    <pc:chgData name="Ilaria Laurenzana" userId="S::ilaria.laurenzana@crob.it::d20e3a4c-5152-4781-9a82-e8e358f0fc6e" providerId="AD" clId="Web-{B570982C-381C-0BC2-93D3-362EDFEEF809}"/>
    <pc:docChg chg="modSld">
      <pc:chgData name="Ilaria Laurenzana" userId="S::ilaria.laurenzana@crob.it::d20e3a4c-5152-4781-9a82-e8e358f0fc6e" providerId="AD" clId="Web-{B570982C-381C-0BC2-93D3-362EDFEEF809}" dt="2025-01-20T13:54:37.959" v="55"/>
      <pc:docMkLst>
        <pc:docMk/>
      </pc:docMkLst>
      <pc:sldChg chg="addSp delSp modSp">
        <pc:chgData name="Ilaria Laurenzana" userId="S::ilaria.laurenzana@crob.it::d20e3a4c-5152-4781-9a82-e8e358f0fc6e" providerId="AD" clId="Web-{B570982C-381C-0BC2-93D3-362EDFEEF809}" dt="2025-01-20T13:54:37.959" v="55"/>
        <pc:sldMkLst>
          <pc:docMk/>
          <pc:sldMk cId="54607325" sldId="256"/>
        </pc:sldMkLst>
        <pc:spChg chg="add mod">
          <ac:chgData name="Ilaria Laurenzana" userId="S::ilaria.laurenzana@crob.it::d20e3a4c-5152-4781-9a82-e8e358f0fc6e" providerId="AD" clId="Web-{B570982C-381C-0BC2-93D3-362EDFEEF809}" dt="2025-01-20T13:54:37.959" v="55"/>
          <ac:spMkLst>
            <pc:docMk/>
            <pc:sldMk cId="54607325" sldId="256"/>
            <ac:spMk id="7" creationId="{62768B13-D83E-CEA6-1C64-F4DDA5FB1F19}"/>
          </ac:spMkLst>
        </pc:spChg>
        <pc:spChg chg="del">
          <ac:chgData name="Ilaria Laurenzana" userId="S::ilaria.laurenzana@crob.it::d20e3a4c-5152-4781-9a82-e8e358f0fc6e" providerId="AD" clId="Web-{B570982C-381C-0BC2-93D3-362EDFEEF809}" dt="2025-01-20T13:37:25.644" v="0"/>
          <ac:spMkLst>
            <pc:docMk/>
            <pc:sldMk cId="54607325" sldId="256"/>
            <ac:spMk id="9" creationId="{672C801C-0498-22E6-17DF-550A24647C06}"/>
          </ac:spMkLst>
        </pc:spChg>
        <pc:spChg chg="add mod">
          <ac:chgData name="Ilaria Laurenzana" userId="S::ilaria.laurenzana@crob.it::d20e3a4c-5152-4781-9a82-e8e358f0fc6e" providerId="AD" clId="Web-{B570982C-381C-0BC2-93D3-362EDFEEF809}" dt="2025-01-20T13:54:37.959" v="54"/>
          <ac:spMkLst>
            <pc:docMk/>
            <pc:sldMk cId="54607325" sldId="256"/>
            <ac:spMk id="11" creationId="{23617C4A-4F10-0EA2-1033-A0E4A93959A3}"/>
          </ac:spMkLst>
        </pc:spChg>
        <pc:spChg chg="add mod">
          <ac:chgData name="Ilaria Laurenzana" userId="S::ilaria.laurenzana@crob.it::d20e3a4c-5152-4781-9a82-e8e358f0fc6e" providerId="AD" clId="Web-{B570982C-381C-0BC2-93D3-362EDFEEF809}" dt="2025-01-20T13:54:37.943" v="53"/>
          <ac:spMkLst>
            <pc:docMk/>
            <pc:sldMk cId="54607325" sldId="256"/>
            <ac:spMk id="12" creationId="{320F4E14-12D2-0480-F2F0-CB86F834ED5A}"/>
          </ac:spMkLst>
        </pc:spChg>
        <pc:cxnChg chg="add del">
          <ac:chgData name="Ilaria Laurenzana" userId="S::ilaria.laurenzana@crob.it::d20e3a4c-5152-4781-9a82-e8e358f0fc6e" providerId="AD" clId="Web-{B570982C-381C-0BC2-93D3-362EDFEEF809}" dt="2025-01-20T13:50:42.232" v="12"/>
          <ac:cxnSpMkLst>
            <pc:docMk/>
            <pc:sldMk cId="54607325" sldId="256"/>
            <ac:cxnSpMk id="2" creationId="{B9D631FF-1779-7014-99F6-FA91C5576F5F}"/>
          </ac:cxnSpMkLst>
        </pc:cxnChg>
        <pc:cxnChg chg="add del mod">
          <ac:chgData name="Ilaria Laurenzana" userId="S::ilaria.laurenzana@crob.it::d20e3a4c-5152-4781-9a82-e8e358f0fc6e" providerId="AD" clId="Web-{B570982C-381C-0BC2-93D3-362EDFEEF809}" dt="2025-01-20T13:51:13.733" v="15"/>
          <ac:cxnSpMkLst>
            <pc:docMk/>
            <pc:sldMk cId="54607325" sldId="256"/>
            <ac:cxnSpMk id="5" creationId="{177455A6-74F3-57AC-1A5A-4BAF3E60DFD8}"/>
          </ac:cxnSpMkLst>
        </pc:cxnChg>
      </pc:sldChg>
      <pc:sldChg chg="modSp">
        <pc:chgData name="Ilaria Laurenzana" userId="S::ilaria.laurenzana@crob.it::d20e3a4c-5152-4781-9a82-e8e358f0fc6e" providerId="AD" clId="Web-{B570982C-381C-0BC2-93D3-362EDFEEF809}" dt="2025-01-20T13:39:09.632" v="10" actId="20577"/>
        <pc:sldMkLst>
          <pc:docMk/>
          <pc:sldMk cId="3041777217" sldId="259"/>
        </pc:sldMkLst>
        <pc:spChg chg="mod">
          <ac:chgData name="Ilaria Laurenzana" userId="S::ilaria.laurenzana@crob.it::d20e3a4c-5152-4781-9a82-e8e358f0fc6e" providerId="AD" clId="Web-{B570982C-381C-0BC2-93D3-362EDFEEF809}" dt="2025-01-20T13:39:09.632" v="10" actId="20577"/>
          <ac:spMkLst>
            <pc:docMk/>
            <pc:sldMk cId="3041777217" sldId="259"/>
            <ac:spMk id="17" creationId="{A7DAA4EA-717C-736C-558A-4784548A7FBF}"/>
          </ac:spMkLst>
        </pc:spChg>
        <pc:spChg chg="mod">
          <ac:chgData name="Ilaria Laurenzana" userId="S::ilaria.laurenzana@crob.it::d20e3a4c-5152-4781-9a82-e8e358f0fc6e" providerId="AD" clId="Web-{B570982C-381C-0BC2-93D3-362EDFEEF809}" dt="2025-01-20T13:39:00.632" v="5" actId="20577"/>
          <ac:spMkLst>
            <pc:docMk/>
            <pc:sldMk cId="3041777217" sldId="259"/>
            <ac:spMk id="32" creationId="{510CAA08-CAEE-EC0B-BACF-F6D1DBF4F3D9}"/>
          </ac:spMkLst>
        </pc:spChg>
      </pc:sldChg>
    </pc:docChg>
  </pc:docChgLst>
  <pc:docChgLst>
    <pc:chgData name="Luciana De Luca" userId="S::luciana.deluca@crob.it::bae8d283-e187-4b8e-966b-081af72c9cd4" providerId="AD" clId="Web-{3D505087-C731-55EC-DAF7-ED721F9821A9}"/>
    <pc:docChg chg="modSld">
      <pc:chgData name="Luciana De Luca" userId="S::luciana.deluca@crob.it::bae8d283-e187-4b8e-966b-081af72c9cd4" providerId="AD" clId="Web-{3D505087-C731-55EC-DAF7-ED721F9821A9}" dt="2025-01-22T09:32:52.424" v="198" actId="1076"/>
      <pc:docMkLst>
        <pc:docMk/>
      </pc:docMkLst>
      <pc:sldChg chg="addSp delSp modSp">
        <pc:chgData name="Luciana De Luca" userId="S::luciana.deluca@crob.it::bae8d283-e187-4b8e-966b-081af72c9cd4" providerId="AD" clId="Web-{3D505087-C731-55EC-DAF7-ED721F9821A9}" dt="2025-01-22T09:18:53.159" v="45"/>
        <pc:sldMkLst>
          <pc:docMk/>
          <pc:sldMk cId="54607325" sldId="256"/>
        </pc:sldMkLst>
        <pc:spChg chg="mod">
          <ac:chgData name="Luciana De Luca" userId="S::luciana.deluca@crob.it::bae8d283-e187-4b8e-966b-081af72c9cd4" providerId="AD" clId="Web-{3D505087-C731-55EC-DAF7-ED721F9821A9}" dt="2025-01-22T09:16:32.188" v="18" actId="20577"/>
          <ac:spMkLst>
            <pc:docMk/>
            <pc:sldMk cId="54607325" sldId="256"/>
            <ac:spMk id="4" creationId="{3C0A09C8-F654-94DD-0DE0-9E3DC579C252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14:40.061" v="5" actId="20577"/>
          <ac:spMkLst>
            <pc:docMk/>
            <pc:sldMk cId="54607325" sldId="256"/>
            <ac:spMk id="5" creationId="{83D236C9-5DF3-1726-CC75-F4E12483C1EA}"/>
          </ac:spMkLst>
        </pc:spChg>
        <pc:spChg chg="add del mod">
          <ac:chgData name="Luciana De Luca" userId="S::luciana.deluca@crob.it::bae8d283-e187-4b8e-966b-081af72c9cd4" providerId="AD" clId="Web-{3D505087-C731-55EC-DAF7-ED721F9821A9}" dt="2025-01-22T09:16:04.312" v="8"/>
          <ac:spMkLst>
            <pc:docMk/>
            <pc:sldMk cId="54607325" sldId="256"/>
            <ac:spMk id="17" creationId="{44E7806D-D7AA-6D6F-5A29-B409869FBA98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18:53.144" v="43"/>
          <ac:spMkLst>
            <pc:docMk/>
            <pc:sldMk cId="54607325" sldId="256"/>
            <ac:spMk id="19" creationId="{8F0A35B5-A4BA-6889-8473-97B3B24B5804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18:53.144" v="44"/>
          <ac:spMkLst>
            <pc:docMk/>
            <pc:sldMk cId="54607325" sldId="256"/>
            <ac:spMk id="20" creationId="{254C29AF-D4C7-8A87-5875-E50EBADAF533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18:53.159" v="45"/>
          <ac:spMkLst>
            <pc:docMk/>
            <pc:sldMk cId="54607325" sldId="256"/>
            <ac:spMk id="21" creationId="{5DE43FD1-CDE2-9216-751D-C3D4503EC99A}"/>
          </ac:spMkLst>
        </pc:spChg>
      </pc:sldChg>
      <pc:sldChg chg="addSp">
        <pc:chgData name="Luciana De Luca" userId="S::luciana.deluca@crob.it::bae8d283-e187-4b8e-966b-081af72c9cd4" providerId="AD" clId="Web-{3D505087-C731-55EC-DAF7-ED721F9821A9}" dt="2025-01-22T09:22:05.835" v="60"/>
        <pc:sldMkLst>
          <pc:docMk/>
          <pc:sldMk cId="363783681" sldId="257"/>
        </pc:sldMkLst>
        <pc:cxnChg chg="add">
          <ac:chgData name="Luciana De Luca" userId="S::luciana.deluca@crob.it::bae8d283-e187-4b8e-966b-081af72c9cd4" providerId="AD" clId="Web-{3D505087-C731-55EC-DAF7-ED721F9821A9}" dt="2025-01-22T09:21:55.756" v="59"/>
          <ac:cxnSpMkLst>
            <pc:docMk/>
            <pc:sldMk cId="363783681" sldId="257"/>
            <ac:cxnSpMk id="9" creationId="{B2128DD0-002F-1F0A-FFC2-F5C6D0C84DC3}"/>
          </ac:cxnSpMkLst>
        </pc:cxnChg>
        <pc:cxnChg chg="add">
          <ac:chgData name="Luciana De Luca" userId="S::luciana.deluca@crob.it::bae8d283-e187-4b8e-966b-081af72c9cd4" providerId="AD" clId="Web-{3D505087-C731-55EC-DAF7-ED721F9821A9}" dt="2025-01-22T09:22:05.835" v="60"/>
          <ac:cxnSpMkLst>
            <pc:docMk/>
            <pc:sldMk cId="363783681" sldId="257"/>
            <ac:cxnSpMk id="15" creationId="{877E60CA-A4C9-A1FF-A150-43F6F324C1B4}"/>
          </ac:cxnSpMkLst>
        </pc:cxnChg>
      </pc:sldChg>
      <pc:sldChg chg="addSp delSp modSp">
        <pc:chgData name="Luciana De Luca" userId="S::luciana.deluca@crob.it::bae8d283-e187-4b8e-966b-081af72c9cd4" providerId="AD" clId="Web-{3D505087-C731-55EC-DAF7-ED721F9821A9}" dt="2025-01-22T09:32:52.424" v="198" actId="1076"/>
        <pc:sldMkLst>
          <pc:docMk/>
          <pc:sldMk cId="3041777217" sldId="259"/>
        </pc:sldMkLst>
        <pc:spChg chg="mod">
          <ac:chgData name="Luciana De Luca" userId="S::luciana.deluca@crob.it::bae8d283-e187-4b8e-966b-081af72c9cd4" providerId="AD" clId="Web-{3D505087-C731-55EC-DAF7-ED721F9821A9}" dt="2025-01-22T09:28:50.733" v="126" actId="1076"/>
          <ac:spMkLst>
            <pc:docMk/>
            <pc:sldMk cId="3041777217" sldId="259"/>
            <ac:spMk id="2" creationId="{8483E537-DA08-1BF0-4885-4347B9DD813A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8:50.639" v="115" actId="1076"/>
          <ac:spMkLst>
            <pc:docMk/>
            <pc:sldMk cId="3041777217" sldId="259"/>
            <ac:spMk id="3" creationId="{D9383272-956E-1143-B1F3-4046ACD9F7A4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8:50.639" v="116" actId="1076"/>
          <ac:spMkLst>
            <pc:docMk/>
            <pc:sldMk cId="3041777217" sldId="259"/>
            <ac:spMk id="4" creationId="{D9EE0480-625F-0C58-5607-942E7DE3DA61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8:50.654" v="117" actId="1076"/>
          <ac:spMkLst>
            <pc:docMk/>
            <pc:sldMk cId="3041777217" sldId="259"/>
            <ac:spMk id="5" creationId="{EB49401C-E3C7-22D5-9635-1E57332A2C2F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9:13.983" v="132" actId="1076"/>
          <ac:spMkLst>
            <pc:docMk/>
            <pc:sldMk cId="3041777217" sldId="259"/>
            <ac:spMk id="6" creationId="{1EAB683E-0C17-DE17-C3E2-36C9D728E75D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9:13.999" v="133" actId="1076"/>
          <ac:spMkLst>
            <pc:docMk/>
            <pc:sldMk cId="3041777217" sldId="259"/>
            <ac:spMk id="7" creationId="{6EBB81A2-00EB-F06C-EAB0-112DB8258A7E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9:13.999" v="134" actId="1076"/>
          <ac:spMkLst>
            <pc:docMk/>
            <pc:sldMk cId="3041777217" sldId="259"/>
            <ac:spMk id="8" creationId="{1962853F-8B90-F7B4-4998-42111F3DFFD0}"/>
          </ac:spMkLst>
        </pc:spChg>
        <pc:spChg chg="del">
          <ac:chgData name="Luciana De Luca" userId="S::luciana.deluca@crob.it::bae8d283-e187-4b8e-966b-081af72c9cd4" providerId="AD" clId="Web-{3D505087-C731-55EC-DAF7-ED721F9821A9}" dt="2025-01-22T09:24:45.197" v="67"/>
          <ac:spMkLst>
            <pc:docMk/>
            <pc:sldMk cId="3041777217" sldId="259"/>
            <ac:spMk id="10" creationId="{C3A0FBB7-3BB2-6251-8263-2B21D6CDFCF2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8:50.670" v="121" actId="1076"/>
          <ac:spMkLst>
            <pc:docMk/>
            <pc:sldMk cId="3041777217" sldId="259"/>
            <ac:spMk id="12" creationId="{412FBE0E-DC61-5D46-51A7-34271F6DA57A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9:14.014" v="135" actId="1076"/>
          <ac:spMkLst>
            <pc:docMk/>
            <pc:sldMk cId="3041777217" sldId="259"/>
            <ac:spMk id="13" creationId="{D9FC3557-A4A2-F6B7-3488-421A3C5DDBF8}"/>
          </ac:spMkLst>
        </pc:spChg>
        <pc:spChg chg="del mod">
          <ac:chgData name="Luciana De Luca" userId="S::luciana.deluca@crob.it::bae8d283-e187-4b8e-966b-081af72c9cd4" providerId="AD" clId="Web-{3D505087-C731-55EC-DAF7-ED721F9821A9}" dt="2025-01-22T09:29:25.780" v="138"/>
          <ac:spMkLst>
            <pc:docMk/>
            <pc:sldMk cId="3041777217" sldId="259"/>
            <ac:spMk id="14" creationId="{DE955119-F561-5070-E7FA-B98341E15066}"/>
          </ac:spMkLst>
        </pc:spChg>
        <pc:spChg chg="del">
          <ac:chgData name="Luciana De Luca" userId="S::luciana.deluca@crob.it::bae8d283-e187-4b8e-966b-081af72c9cd4" providerId="AD" clId="Web-{3D505087-C731-55EC-DAF7-ED721F9821A9}" dt="2025-01-22T09:29:20.842" v="136"/>
          <ac:spMkLst>
            <pc:docMk/>
            <pc:sldMk cId="3041777217" sldId="259"/>
            <ac:spMk id="17" creationId="{A7DAA4EA-717C-736C-558A-4784548A7FBF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2:09.658" v="195" actId="1076"/>
          <ac:spMkLst>
            <pc:docMk/>
            <pc:sldMk cId="3041777217" sldId="259"/>
            <ac:spMk id="18" creationId="{D1650DBB-F4FA-B2DC-2D58-A64A6289F73B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1:59.314" v="190" actId="1076"/>
          <ac:spMkLst>
            <pc:docMk/>
            <pc:sldMk cId="3041777217" sldId="259"/>
            <ac:spMk id="19" creationId="{87C08781-3A6E-1D74-5923-26B0BCCA7AB0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1:59.330" v="191" actId="1076"/>
          <ac:spMkLst>
            <pc:docMk/>
            <pc:sldMk cId="3041777217" sldId="259"/>
            <ac:spMk id="21" creationId="{63950A08-EAFA-C811-516F-E22B7E7EB193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2:52.424" v="198" actId="1076"/>
          <ac:spMkLst>
            <pc:docMk/>
            <pc:sldMk cId="3041777217" sldId="259"/>
            <ac:spMk id="22" creationId="{45B75973-7598-B212-443C-B7316234E6A8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2:31.205" v="196" actId="1076"/>
          <ac:spMkLst>
            <pc:docMk/>
            <pc:sldMk cId="3041777217" sldId="259"/>
            <ac:spMk id="23" creationId="{98C4C43B-2616-97A3-268C-4D129322F49B}"/>
          </ac:spMkLst>
        </pc:spChg>
        <pc:spChg chg="del">
          <ac:chgData name="Luciana De Luca" userId="S::luciana.deluca@crob.it::bae8d283-e187-4b8e-966b-081af72c9cd4" providerId="AD" clId="Web-{3D505087-C731-55EC-DAF7-ED721F9821A9}" dt="2025-01-22T09:24:41.009" v="66"/>
          <ac:spMkLst>
            <pc:docMk/>
            <pc:sldMk cId="3041777217" sldId="259"/>
            <ac:spMk id="24" creationId="{29DA8602-7783-458A-A099-477A73DDC2D3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32:40.143" v="197" actId="1076"/>
          <ac:spMkLst>
            <pc:docMk/>
            <pc:sldMk cId="3041777217" sldId="259"/>
            <ac:spMk id="25" creationId="{9285FD73-229E-5B8D-0B36-B9D6A2FA9609}"/>
          </ac:spMkLst>
        </pc:spChg>
        <pc:spChg chg="mod">
          <ac:chgData name="Luciana De Luca" userId="S::luciana.deluca@crob.it::bae8d283-e187-4b8e-966b-081af72c9cd4" providerId="AD" clId="Web-{3D505087-C731-55EC-DAF7-ED721F9821A9}" dt="2025-01-22T09:29:39.124" v="143" actId="1076"/>
          <ac:spMkLst>
            <pc:docMk/>
            <pc:sldMk cId="3041777217" sldId="259"/>
            <ac:spMk id="26" creationId="{14B962F0-A895-0E37-29D8-EF0E3B4895CE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29:53.577" v="144" actId="1076"/>
          <ac:spMkLst>
            <pc:docMk/>
            <pc:sldMk cId="3041777217" sldId="259"/>
            <ac:spMk id="27" creationId="{BFC3230A-94F0-5BB6-69C6-3698CD0A532A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29:53.593" v="145" actId="1076"/>
          <ac:spMkLst>
            <pc:docMk/>
            <pc:sldMk cId="3041777217" sldId="259"/>
            <ac:spMk id="28" creationId="{CE261296-4712-333D-2BB7-C987B2A56609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31:26.626" v="166" actId="20577"/>
          <ac:spMkLst>
            <pc:docMk/>
            <pc:sldMk cId="3041777217" sldId="259"/>
            <ac:spMk id="29" creationId="{459AB9DC-2435-1910-2D43-3496C914A8CD}"/>
          </ac:spMkLst>
        </pc:spChg>
        <pc:spChg chg="add mod">
          <ac:chgData name="Luciana De Luca" userId="S::luciana.deluca@crob.it::bae8d283-e187-4b8e-966b-081af72c9cd4" providerId="AD" clId="Web-{3D505087-C731-55EC-DAF7-ED721F9821A9}" dt="2025-01-22T09:31:21.376" v="164" actId="20577"/>
          <ac:spMkLst>
            <pc:docMk/>
            <pc:sldMk cId="3041777217" sldId="259"/>
            <ac:spMk id="30" creationId="{B66AE4EF-A825-06AA-0A73-CF42A87A26C9}"/>
          </ac:spMkLst>
        </pc:spChg>
        <pc:spChg chg="del">
          <ac:chgData name="Luciana De Luca" userId="S::luciana.deluca@crob.it::bae8d283-e187-4b8e-966b-081af72c9cd4" providerId="AD" clId="Web-{3D505087-C731-55EC-DAF7-ED721F9821A9}" dt="2025-01-22T09:22:24.757" v="61"/>
          <ac:spMkLst>
            <pc:docMk/>
            <pc:sldMk cId="3041777217" sldId="259"/>
            <ac:spMk id="32" creationId="{510CAA08-CAEE-EC0B-BACF-F6D1DBF4F3D9}"/>
          </ac:spMkLst>
        </pc:spChg>
        <pc:picChg chg="mod modCrop">
          <ac:chgData name="Luciana De Luca" userId="S::luciana.deluca@crob.it::bae8d283-e187-4b8e-966b-081af72c9cd4" providerId="AD" clId="Web-{3D505087-C731-55EC-DAF7-ED721F9821A9}" dt="2025-01-22T09:31:45.611" v="175" actId="1076"/>
          <ac:picMkLst>
            <pc:docMk/>
            <pc:sldMk cId="3041777217" sldId="259"/>
            <ac:picMk id="11" creationId="{E7E617B5-147A-FD5C-0A2A-729F81B36DD8}"/>
          </ac:picMkLst>
        </pc:picChg>
        <pc:picChg chg="mod modCrop">
          <ac:chgData name="Luciana De Luca" userId="S::luciana.deluca@crob.it::bae8d283-e187-4b8e-966b-081af72c9cd4" providerId="AD" clId="Web-{3D505087-C731-55EC-DAF7-ED721F9821A9}" dt="2025-01-22T09:28:50.639" v="114" actId="1076"/>
          <ac:picMkLst>
            <pc:docMk/>
            <pc:sldMk cId="3041777217" sldId="259"/>
            <ac:picMk id="15" creationId="{6D9C3E15-C4DC-3774-DF71-2A8088495B5A}"/>
          </ac:picMkLst>
        </pc:picChg>
        <pc:picChg chg="mod modCrop">
          <ac:chgData name="Luciana De Luca" userId="S::luciana.deluca@crob.it::bae8d283-e187-4b8e-966b-081af72c9cd4" providerId="AD" clId="Web-{3D505087-C731-55EC-DAF7-ED721F9821A9}" dt="2025-01-22T09:31:45.626" v="176" actId="1076"/>
          <ac:picMkLst>
            <pc:docMk/>
            <pc:sldMk cId="3041777217" sldId="259"/>
            <ac:picMk id="16" creationId="{28928DC9-E70D-6CC9-1E80-4C9C56902F99}"/>
          </ac:picMkLst>
        </pc:picChg>
        <pc:picChg chg="mod modCrop">
          <ac:chgData name="Luciana De Luca" userId="S::luciana.deluca@crob.it::bae8d283-e187-4b8e-966b-081af72c9cd4" providerId="AD" clId="Web-{3D505087-C731-55EC-DAF7-ED721F9821A9}" dt="2025-01-22T09:29:03.108" v="131" actId="1076"/>
          <ac:picMkLst>
            <pc:docMk/>
            <pc:sldMk cId="3041777217" sldId="259"/>
            <ac:picMk id="20" creationId="{DDF6EC57-2664-ED95-F2AE-47ABE59D6AC5}"/>
          </ac:picMkLst>
        </pc:picChg>
      </pc:sldChg>
      <pc:sldChg chg="addSp modSp">
        <pc:chgData name="Luciana De Luca" userId="S::luciana.deluca@crob.it::bae8d283-e187-4b8e-966b-081af72c9cd4" providerId="AD" clId="Web-{3D505087-C731-55EC-DAF7-ED721F9821A9}" dt="2025-01-22T09:21:38.428" v="58" actId="1076"/>
        <pc:sldMkLst>
          <pc:docMk/>
          <pc:sldMk cId="639010659" sldId="264"/>
        </pc:sldMkLst>
        <pc:grpChg chg="add mod">
          <ac:chgData name="Luciana De Luca" userId="S::luciana.deluca@crob.it::bae8d283-e187-4b8e-966b-081af72c9cd4" providerId="AD" clId="Web-{3D505087-C731-55EC-DAF7-ED721F9821A9}" dt="2025-01-22T09:21:31.240" v="56" actId="1076"/>
          <ac:grpSpMkLst>
            <pc:docMk/>
            <pc:sldMk cId="639010659" sldId="264"/>
            <ac:grpSpMk id="15" creationId="{4AFEE778-BC38-B479-75A7-6AD10EDE834A}"/>
          </ac:grpSpMkLst>
        </pc:grpChg>
        <pc:grpChg chg="add mod">
          <ac:chgData name="Luciana De Luca" userId="S::luciana.deluca@crob.it::bae8d283-e187-4b8e-966b-081af72c9cd4" providerId="AD" clId="Web-{3D505087-C731-55EC-DAF7-ED721F9821A9}" dt="2025-01-22T09:21:38.428" v="58" actId="1076"/>
          <ac:grpSpMkLst>
            <pc:docMk/>
            <pc:sldMk cId="639010659" sldId="264"/>
            <ac:grpSpMk id="16" creationId="{5F82101A-FBCB-F4F2-5F12-E272BE0DC857}"/>
          </ac:grpSpMkLst>
        </pc:grpChg>
        <pc:picChg chg="mod">
          <ac:chgData name="Luciana De Luca" userId="S::luciana.deluca@crob.it::bae8d283-e187-4b8e-966b-081af72c9cd4" providerId="AD" clId="Web-{3D505087-C731-55EC-DAF7-ED721F9821A9}" dt="2025-01-22T09:20:40.239" v="50" actId="1076"/>
          <ac:picMkLst>
            <pc:docMk/>
            <pc:sldMk cId="639010659" sldId="264"/>
            <ac:picMk id="3074" creationId="{99DFA977-70AC-6E3A-F875-7193024AE895}"/>
          </ac:picMkLst>
        </pc:picChg>
        <pc:cxnChg chg="add">
          <ac:chgData name="Luciana De Luca" userId="S::luciana.deluca@crob.it::bae8d283-e187-4b8e-966b-081af72c9cd4" providerId="AD" clId="Web-{3D505087-C731-55EC-DAF7-ED721F9821A9}" dt="2025-01-22T09:19:53.473" v="46"/>
          <ac:cxnSpMkLst>
            <pc:docMk/>
            <pc:sldMk cId="639010659" sldId="264"/>
            <ac:cxnSpMk id="12" creationId="{11B3ECEB-9806-E1BB-C073-E204EFB142DB}"/>
          </ac:cxnSpMkLst>
        </pc:cxnChg>
        <pc:cxnChg chg="add">
          <ac:chgData name="Luciana De Luca" userId="S::luciana.deluca@crob.it::bae8d283-e187-4b8e-966b-081af72c9cd4" providerId="AD" clId="Web-{3D505087-C731-55EC-DAF7-ED721F9821A9}" dt="2025-01-22T09:20:02.817" v="47"/>
          <ac:cxnSpMkLst>
            <pc:docMk/>
            <pc:sldMk cId="639010659" sldId="264"/>
            <ac:cxnSpMk id="14" creationId="{D6268132-4530-9861-F41B-E03ED985C481}"/>
          </ac:cxnSpMkLst>
        </pc:cxnChg>
      </pc:sldChg>
    </pc:docChg>
  </pc:docChgLst>
  <pc:docChgLst>
    <pc:chgData name="Antonella Caivano" userId="S::antonella.caivano@crob.it::5513c8a0-81c4-4e80-a194-a4422c619f78" providerId="AD" clId="Web-{B255346C-6C06-8E64-8645-40673A64E425}"/>
    <pc:docChg chg="modSld">
      <pc:chgData name="Antonella Caivano" userId="S::antonella.caivano@crob.it::5513c8a0-81c4-4e80-a194-a4422c619f78" providerId="AD" clId="Web-{B255346C-6C06-8E64-8645-40673A64E425}" dt="2025-01-24T14:15:08.440" v="67"/>
      <pc:docMkLst>
        <pc:docMk/>
      </pc:docMkLst>
      <pc:sldChg chg="addSp delSp modSp">
        <pc:chgData name="Antonella Caivano" userId="S::antonella.caivano@crob.it::5513c8a0-81c4-4e80-a194-a4422c619f78" providerId="AD" clId="Web-{B255346C-6C06-8E64-8645-40673A64E425}" dt="2025-01-24T14:15:08.440" v="67"/>
        <pc:sldMkLst>
          <pc:docMk/>
          <pc:sldMk cId="54607325" sldId="256"/>
        </pc:sldMkLst>
        <pc:spChg chg="mod">
          <ac:chgData name="Antonella Caivano" userId="S::antonella.caivano@crob.it::5513c8a0-81c4-4e80-a194-a4422c619f78" providerId="AD" clId="Web-{B255346C-6C06-8E64-8645-40673A64E425}" dt="2025-01-24T14:13:41.312" v="49" actId="14100"/>
          <ac:spMkLst>
            <pc:docMk/>
            <pc:sldMk cId="54607325" sldId="256"/>
            <ac:spMk id="2" creationId="{35BC3299-3330-D11C-6379-F110ED812014}"/>
          </ac:spMkLst>
        </pc:spChg>
        <pc:spChg chg="mod">
          <ac:chgData name="Antonella Caivano" userId="S::antonella.caivano@crob.it::5513c8a0-81c4-4e80-a194-a4422c619f78" providerId="AD" clId="Web-{B255346C-6C06-8E64-8645-40673A64E425}" dt="2025-01-24T13:37:58.769" v="0" actId="1076"/>
          <ac:spMkLst>
            <pc:docMk/>
            <pc:sldMk cId="54607325" sldId="256"/>
            <ac:spMk id="3" creationId="{21B078B1-FEED-C6E2-9E5A-D94016EAD6B0}"/>
          </ac:spMkLst>
        </pc:spChg>
        <pc:spChg chg="mod topLvl">
          <ac:chgData name="Antonella Caivano" userId="S::antonella.caivano@crob.it::5513c8a0-81c4-4e80-a194-a4422c619f78" providerId="AD" clId="Web-{B255346C-6C06-8E64-8645-40673A64E425}" dt="2025-01-24T14:07:42.475" v="24" actId="1076"/>
          <ac:spMkLst>
            <pc:docMk/>
            <pc:sldMk cId="54607325" sldId="256"/>
            <ac:spMk id="4" creationId="{3C0A09C8-F654-94DD-0DE0-9E3DC579C252}"/>
          </ac:spMkLst>
        </pc:spChg>
        <pc:spChg chg="mod ord">
          <ac:chgData name="Antonella Caivano" userId="S::antonella.caivano@crob.it::5513c8a0-81c4-4e80-a194-a4422c619f78" providerId="AD" clId="Web-{B255346C-6C06-8E64-8645-40673A64E425}" dt="2025-01-24T14:14:32.720" v="61" actId="1076"/>
          <ac:spMkLst>
            <pc:docMk/>
            <pc:sldMk cId="54607325" sldId="256"/>
            <ac:spMk id="5" creationId="{83D236C9-5DF3-1726-CC75-F4E12483C1EA}"/>
          </ac:spMkLst>
        </pc:spChg>
        <pc:spChg chg="mod">
          <ac:chgData name="Antonella Caivano" userId="S::antonella.caivano@crob.it::5513c8a0-81c4-4e80-a194-a4422c619f78" providerId="AD" clId="Web-{B255346C-6C06-8E64-8645-40673A64E425}" dt="2025-01-24T14:07:05.942" v="18" actId="1076"/>
          <ac:spMkLst>
            <pc:docMk/>
            <pc:sldMk cId="54607325" sldId="256"/>
            <ac:spMk id="6" creationId="{19879634-B680-2F50-D93B-1807A2018B0C}"/>
          </ac:spMkLst>
        </pc:spChg>
        <pc:spChg chg="topLvl">
          <ac:chgData name="Antonella Caivano" userId="S::antonella.caivano@crob.it::5513c8a0-81c4-4e80-a194-a4422c619f78" providerId="AD" clId="Web-{B255346C-6C06-8E64-8645-40673A64E425}" dt="2025-01-24T14:06:10.206" v="10"/>
          <ac:spMkLst>
            <pc:docMk/>
            <pc:sldMk cId="54607325" sldId="256"/>
            <ac:spMk id="7" creationId="{62768B13-D83E-CEA6-1C64-F4DDA5FB1F19}"/>
          </ac:spMkLst>
        </pc:spChg>
        <pc:spChg chg="topLvl">
          <ac:chgData name="Antonella Caivano" userId="S::antonella.caivano@crob.it::5513c8a0-81c4-4e80-a194-a4422c619f78" providerId="AD" clId="Web-{B255346C-6C06-8E64-8645-40673A64E425}" dt="2025-01-24T14:06:10.206" v="10"/>
          <ac:spMkLst>
            <pc:docMk/>
            <pc:sldMk cId="54607325" sldId="256"/>
            <ac:spMk id="11" creationId="{23617C4A-4F10-0EA2-1033-A0E4A93959A3}"/>
          </ac:spMkLst>
        </pc:spChg>
        <pc:spChg chg="topLvl">
          <ac:chgData name="Antonella Caivano" userId="S::antonella.caivano@crob.it::5513c8a0-81c4-4e80-a194-a4422c619f78" providerId="AD" clId="Web-{B255346C-6C06-8E64-8645-40673A64E425}" dt="2025-01-24T14:06:10.206" v="10"/>
          <ac:spMkLst>
            <pc:docMk/>
            <pc:sldMk cId="54607325" sldId="256"/>
            <ac:spMk id="12" creationId="{320F4E14-12D2-0480-F2F0-CB86F834ED5A}"/>
          </ac:spMkLst>
        </pc:spChg>
        <pc:spChg chg="mod">
          <ac:chgData name="Antonella Caivano" userId="S::antonella.caivano@crob.it::5513c8a0-81c4-4e80-a194-a4422c619f78" providerId="AD" clId="Web-{B255346C-6C06-8E64-8645-40673A64E425}" dt="2025-01-24T14:12:31.904" v="37" actId="1076"/>
          <ac:spMkLst>
            <pc:docMk/>
            <pc:sldMk cId="54607325" sldId="256"/>
            <ac:spMk id="13" creationId="{41601F00-035F-1230-E75F-BFEDBB8A522C}"/>
          </ac:spMkLst>
        </pc:spChg>
        <pc:spChg chg="mod">
          <ac:chgData name="Antonella Caivano" userId="S::antonella.caivano@crob.it::5513c8a0-81c4-4e80-a194-a4422c619f78" providerId="AD" clId="Web-{B255346C-6C06-8E64-8645-40673A64E425}" dt="2025-01-24T14:14:02.172" v="53" actId="1076"/>
          <ac:spMkLst>
            <pc:docMk/>
            <pc:sldMk cId="54607325" sldId="256"/>
            <ac:spMk id="14" creationId="{6805E781-2884-65B1-D274-18EACE290765}"/>
          </ac:spMkLst>
        </pc:spChg>
        <pc:spChg chg="mod topLvl">
          <ac:chgData name="Antonella Caivano" userId="S::antonella.caivano@crob.it::5513c8a0-81c4-4e80-a194-a4422c619f78" providerId="AD" clId="Web-{B255346C-6C06-8E64-8645-40673A64E425}" dt="2025-01-24T14:08:03.584" v="26" actId="1076"/>
          <ac:spMkLst>
            <pc:docMk/>
            <pc:sldMk cId="54607325" sldId="256"/>
            <ac:spMk id="19" creationId="{8F0A35B5-A4BA-6889-8473-97B3B24B5804}"/>
          </ac:spMkLst>
        </pc:spChg>
        <pc:spChg chg="mod topLvl">
          <ac:chgData name="Antonella Caivano" userId="S::antonella.caivano@crob.it::5513c8a0-81c4-4e80-a194-a4422c619f78" providerId="AD" clId="Web-{B255346C-6C06-8E64-8645-40673A64E425}" dt="2025-01-24T14:08:14.694" v="28" actId="1076"/>
          <ac:spMkLst>
            <pc:docMk/>
            <pc:sldMk cId="54607325" sldId="256"/>
            <ac:spMk id="20" creationId="{254C29AF-D4C7-8A87-5875-E50EBADAF533}"/>
          </ac:spMkLst>
        </pc:spChg>
        <pc:spChg chg="mod topLvl">
          <ac:chgData name="Antonella Caivano" userId="S::antonella.caivano@crob.it::5513c8a0-81c4-4e80-a194-a4422c619f78" providerId="AD" clId="Web-{B255346C-6C06-8E64-8645-40673A64E425}" dt="2025-01-24T14:08:09.491" v="27" actId="1076"/>
          <ac:spMkLst>
            <pc:docMk/>
            <pc:sldMk cId="54607325" sldId="256"/>
            <ac:spMk id="21" creationId="{5DE43FD1-CDE2-9216-751D-C3D4503EC99A}"/>
          </ac:spMkLst>
        </pc:spChg>
        <pc:spChg chg="add mod">
          <ac:chgData name="Antonella Caivano" userId="S::antonella.caivano@crob.it::5513c8a0-81c4-4e80-a194-a4422c619f78" providerId="AD" clId="Web-{B255346C-6C06-8E64-8645-40673A64E425}" dt="2025-01-24T14:07:20.474" v="21" actId="1076"/>
          <ac:spMkLst>
            <pc:docMk/>
            <pc:sldMk cId="54607325" sldId="256"/>
            <ac:spMk id="22" creationId="{B92C5C4C-4F39-462C-EB6C-527AC3856ABE}"/>
          </ac:spMkLst>
        </pc:spChg>
        <pc:spChg chg="add mod">
          <ac:chgData name="Antonella Caivano" userId="S::antonella.caivano@crob.it::5513c8a0-81c4-4e80-a194-a4422c619f78" providerId="AD" clId="Web-{B255346C-6C06-8E64-8645-40673A64E425}" dt="2025-01-24T14:14:57.471" v="66" actId="1076"/>
          <ac:spMkLst>
            <pc:docMk/>
            <pc:sldMk cId="54607325" sldId="256"/>
            <ac:spMk id="24" creationId="{609C790F-A35B-3EB5-1764-1C8678287620}"/>
          </ac:spMkLst>
        </pc:spChg>
        <pc:grpChg chg="mod topLvl">
          <ac:chgData name="Antonella Caivano" userId="S::antonella.caivano@crob.it::5513c8a0-81c4-4e80-a194-a4422c619f78" providerId="AD" clId="Web-{B255346C-6C06-8E64-8645-40673A64E425}" dt="2025-01-24T14:07:53.897" v="25" actId="14100"/>
          <ac:grpSpMkLst>
            <pc:docMk/>
            <pc:sldMk cId="54607325" sldId="256"/>
            <ac:grpSpMk id="16" creationId="{82ED57A8-E163-4C7C-4862-0F3EB2F8652C}"/>
          </ac:grpSpMkLst>
        </pc:grpChg>
        <pc:grpChg chg="add del mod">
          <ac:chgData name="Antonella Caivano" userId="S::antonella.caivano@crob.it::5513c8a0-81c4-4e80-a194-a4422c619f78" providerId="AD" clId="Web-{B255346C-6C06-8E64-8645-40673A64E425}" dt="2025-01-24T14:06:10.206" v="10"/>
          <ac:grpSpMkLst>
            <pc:docMk/>
            <pc:sldMk cId="54607325" sldId="256"/>
            <ac:grpSpMk id="17" creationId="{339439C1-A9B4-1021-2D7D-797E7AF43EE8}"/>
          </ac:grpSpMkLst>
        </pc:grpChg>
        <pc:grpChg chg="add mod">
          <ac:chgData name="Antonella Caivano" userId="S::antonella.caivano@crob.it::5513c8a0-81c4-4e80-a194-a4422c619f78" providerId="AD" clId="Web-{B255346C-6C06-8E64-8645-40673A64E425}" dt="2025-01-24T14:08:35.070" v="31" actId="1076"/>
          <ac:grpSpMkLst>
            <pc:docMk/>
            <pc:sldMk cId="54607325" sldId="256"/>
            <ac:grpSpMk id="23" creationId="{A896DAAD-FA97-E639-FBD4-3EDE1C451B71}"/>
          </ac:grpSpMkLst>
        </pc:grpChg>
        <pc:grpChg chg="add">
          <ac:chgData name="Antonella Caivano" userId="S::antonella.caivano@crob.it::5513c8a0-81c4-4e80-a194-a4422c619f78" providerId="AD" clId="Web-{B255346C-6C06-8E64-8645-40673A64E425}" dt="2025-01-24T14:15:08.440" v="67"/>
          <ac:grpSpMkLst>
            <pc:docMk/>
            <pc:sldMk cId="54607325" sldId="256"/>
            <ac:grpSpMk id="25" creationId="{7444C4B0-CEDB-6412-65BE-DD65F5FD57A7}"/>
          </ac:grpSpMkLst>
        </pc:grpChg>
        <pc:picChg chg="mod">
          <ac:chgData name="Antonella Caivano" userId="S::antonella.caivano@crob.it::5513c8a0-81c4-4e80-a194-a4422c619f78" providerId="AD" clId="Web-{B255346C-6C06-8E64-8645-40673A64E425}" dt="2025-01-24T13:38:12.426" v="3" actId="1076"/>
          <ac:picMkLst>
            <pc:docMk/>
            <pc:sldMk cId="54607325" sldId="256"/>
            <ac:picMk id="8" creationId="{3BA3FB26-183B-EEE9-D51A-4E269BE79FFC}"/>
          </ac:picMkLst>
        </pc:picChg>
        <pc:picChg chg="mod">
          <ac:chgData name="Antonella Caivano" userId="S::antonella.caivano@crob.it::5513c8a0-81c4-4e80-a194-a4422c619f78" providerId="AD" clId="Web-{B255346C-6C06-8E64-8645-40673A64E425}" dt="2025-01-24T14:08:42.132" v="32" actId="1076"/>
          <ac:picMkLst>
            <pc:docMk/>
            <pc:sldMk cId="54607325" sldId="256"/>
            <ac:picMk id="10" creationId="{B5A2D91D-B6D3-DFD1-7B76-5BC767808B5E}"/>
          </ac:picMkLst>
        </pc:picChg>
        <pc:picChg chg="add mod">
          <ac:chgData name="Antonella Caivano" userId="S::antonella.caivano@crob.it::5513c8a0-81c4-4e80-a194-a4422c619f78" providerId="AD" clId="Web-{B255346C-6C06-8E64-8645-40673A64E425}" dt="2025-01-24T14:08:47.648" v="33" actId="1076"/>
          <ac:picMkLst>
            <pc:docMk/>
            <pc:sldMk cId="54607325" sldId="256"/>
            <ac:picMk id="18" creationId="{FD0845AF-1684-4892-1E4F-93626352F7C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DD250-FDEE-4480-8402-5BBC9BD60695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49500" y="1143000"/>
            <a:ext cx="2159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9F92BB-CD1F-484A-9CDD-101DDCC8C58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118700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1pPr>
    <a:lvl2pPr marL="1468755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2pPr>
    <a:lvl3pPr marL="2937510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3pPr>
    <a:lvl4pPr marL="4406265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4pPr>
    <a:lvl5pPr marL="5875020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5pPr>
    <a:lvl6pPr marL="7343775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6pPr>
    <a:lvl7pPr marL="8812530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7pPr>
    <a:lvl8pPr marL="10281285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8pPr>
    <a:lvl9pPr marL="11750040" algn="l" defTabSz="2937510" rtl="0" eaLnBrk="1" latinLnBrk="0" hangingPunct="1">
      <a:defRPr sz="385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29375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/>
              <a:t>Confronto A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9F92BB-CD1F-484A-9CDD-101DDCC8C58B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4051970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/>
              <a:t>Confronto B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9F92BB-CD1F-484A-9CDD-101DDCC8C58B}" type="slidenum">
              <a:rPr lang="it-IT" smtClean="0"/>
              <a:pPr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4318770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/>
              <a:t>Confronto C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9F92BB-CD1F-484A-9CDD-101DDCC8C58B}" type="slidenum">
              <a:rPr lang="it-IT" smtClean="0"/>
              <a:pPr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378802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998" y="5891626"/>
            <a:ext cx="21419979" cy="12533242"/>
          </a:xfrm>
        </p:spPr>
        <p:txBody>
          <a:bodyPr anchor="b"/>
          <a:lstStyle>
            <a:lvl1pPr algn="ctr">
              <a:defRPr sz="16535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997" y="18908198"/>
            <a:ext cx="18899981" cy="8691601"/>
          </a:xfrm>
        </p:spPr>
        <p:txBody>
          <a:bodyPr/>
          <a:lstStyle>
            <a:lvl1pPr marL="0" indent="0" algn="ctr">
              <a:buNone/>
              <a:defRPr sz="6614"/>
            </a:lvl1pPr>
            <a:lvl2pPr marL="1259997" indent="0" algn="ctr">
              <a:buNone/>
              <a:defRPr sz="5512"/>
            </a:lvl2pPr>
            <a:lvl3pPr marL="2519995" indent="0" algn="ctr">
              <a:buNone/>
              <a:defRPr sz="4961"/>
            </a:lvl3pPr>
            <a:lvl4pPr marL="3779992" indent="0" algn="ctr">
              <a:buNone/>
              <a:defRPr sz="4409"/>
            </a:lvl4pPr>
            <a:lvl5pPr marL="5039990" indent="0" algn="ctr">
              <a:buNone/>
              <a:defRPr sz="4409"/>
            </a:lvl5pPr>
            <a:lvl6pPr marL="6299987" indent="0" algn="ctr">
              <a:buNone/>
              <a:defRPr sz="4409"/>
            </a:lvl6pPr>
            <a:lvl7pPr marL="7559985" indent="0" algn="ctr">
              <a:buNone/>
              <a:defRPr sz="4409"/>
            </a:lvl7pPr>
            <a:lvl8pPr marL="8819982" indent="0" algn="ctr">
              <a:buNone/>
              <a:defRPr sz="4409"/>
            </a:lvl8pPr>
            <a:lvl9pPr marL="10079980" indent="0" algn="ctr">
              <a:buNone/>
              <a:defRPr sz="4409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632201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522632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3733" y="1916653"/>
            <a:ext cx="5433745" cy="3050811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500" y="1916653"/>
            <a:ext cx="15986234" cy="3050811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87584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17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375" y="8974945"/>
            <a:ext cx="21734978" cy="14974888"/>
          </a:xfrm>
        </p:spPr>
        <p:txBody>
          <a:bodyPr anchor="b"/>
          <a:lstStyle>
            <a:lvl1pPr>
              <a:defRPr sz="16535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375" y="24091502"/>
            <a:ext cx="21734978" cy="7874940"/>
          </a:xfrm>
        </p:spPr>
        <p:txBody>
          <a:bodyPr/>
          <a:lstStyle>
            <a:lvl1pPr marL="0" indent="0">
              <a:buNone/>
              <a:defRPr sz="6614">
                <a:solidFill>
                  <a:schemeClr val="tx1">
                    <a:tint val="82000"/>
                  </a:schemeClr>
                </a:solidFill>
              </a:defRPr>
            </a:lvl1pPr>
            <a:lvl2pPr marL="1259997" indent="0">
              <a:buNone/>
              <a:defRPr sz="5512">
                <a:solidFill>
                  <a:schemeClr val="tx1">
                    <a:tint val="82000"/>
                  </a:schemeClr>
                </a:solidFill>
              </a:defRPr>
            </a:lvl2pPr>
            <a:lvl3pPr marL="2519995" indent="0">
              <a:buNone/>
              <a:defRPr sz="4961">
                <a:solidFill>
                  <a:schemeClr val="tx1">
                    <a:tint val="82000"/>
                  </a:schemeClr>
                </a:solidFill>
              </a:defRPr>
            </a:lvl3pPr>
            <a:lvl4pPr marL="3779992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4pPr>
            <a:lvl5pPr marL="5039990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5pPr>
            <a:lvl6pPr marL="6299987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6pPr>
            <a:lvl7pPr marL="7559985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7pPr>
            <a:lvl8pPr marL="8819982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8pPr>
            <a:lvl9pPr marL="10079980" indent="0">
              <a:buNone/>
              <a:defRPr sz="440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483826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498" y="9583264"/>
            <a:ext cx="10709989" cy="2284150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7488" y="9583264"/>
            <a:ext cx="10709989" cy="2284150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385841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1" y="1916661"/>
            <a:ext cx="21734978" cy="6958285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783" y="8824938"/>
            <a:ext cx="10660769" cy="4324966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783" y="13149904"/>
            <a:ext cx="10660769" cy="1934152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7489" y="8824938"/>
            <a:ext cx="10713272" cy="4324966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7489" y="13149904"/>
            <a:ext cx="10713272" cy="1934152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866645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738892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488942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399982"/>
            <a:ext cx="8127648" cy="8399939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272" y="5183304"/>
            <a:ext cx="12757487" cy="25583147"/>
          </a:xfrm>
        </p:spPr>
        <p:txBody>
          <a:bodyPr/>
          <a:lstStyle>
            <a:lvl1pPr>
              <a:defRPr sz="8819"/>
            </a:lvl1pPr>
            <a:lvl2pPr>
              <a:defRPr sz="7717"/>
            </a:lvl2pPr>
            <a:lvl3pPr>
              <a:defRPr sz="6614"/>
            </a:lvl3pPr>
            <a:lvl4pPr>
              <a:defRPr sz="5512"/>
            </a:lvl4pPr>
            <a:lvl5pPr>
              <a:defRPr sz="5512"/>
            </a:lvl5pPr>
            <a:lvl6pPr>
              <a:defRPr sz="5512"/>
            </a:lvl6pPr>
            <a:lvl7pPr>
              <a:defRPr sz="5512"/>
            </a:lvl7pPr>
            <a:lvl8pPr>
              <a:defRPr sz="5512"/>
            </a:lvl8pPr>
            <a:lvl9pPr>
              <a:defRPr sz="551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10799922"/>
            <a:ext cx="8127648" cy="20008190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148969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399982"/>
            <a:ext cx="8127648" cy="8399939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272" y="5183304"/>
            <a:ext cx="12757487" cy="25583147"/>
          </a:xfrm>
        </p:spPr>
        <p:txBody>
          <a:bodyPr anchor="t"/>
          <a:lstStyle>
            <a:lvl1pPr marL="0" indent="0">
              <a:buNone/>
              <a:defRPr sz="8819"/>
            </a:lvl1pPr>
            <a:lvl2pPr marL="1259997" indent="0">
              <a:buNone/>
              <a:defRPr sz="7717"/>
            </a:lvl2pPr>
            <a:lvl3pPr marL="2519995" indent="0">
              <a:buNone/>
              <a:defRPr sz="6614"/>
            </a:lvl3pPr>
            <a:lvl4pPr marL="3779992" indent="0">
              <a:buNone/>
              <a:defRPr sz="5512"/>
            </a:lvl4pPr>
            <a:lvl5pPr marL="5039990" indent="0">
              <a:buNone/>
              <a:defRPr sz="5512"/>
            </a:lvl5pPr>
            <a:lvl6pPr marL="6299987" indent="0">
              <a:buNone/>
              <a:defRPr sz="5512"/>
            </a:lvl6pPr>
            <a:lvl7pPr marL="7559985" indent="0">
              <a:buNone/>
              <a:defRPr sz="5512"/>
            </a:lvl7pPr>
            <a:lvl8pPr marL="8819982" indent="0">
              <a:buNone/>
              <a:defRPr sz="5512"/>
            </a:lvl8pPr>
            <a:lvl9pPr marL="10079980" indent="0">
              <a:buNone/>
              <a:defRPr sz="5512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10799922"/>
            <a:ext cx="8127648" cy="20008190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738858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499" y="1916661"/>
            <a:ext cx="21734978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499" y="9583264"/>
            <a:ext cx="21734978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498" y="33366432"/>
            <a:ext cx="5669994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30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8C929D-44EE-43AE-8695-C5EF38360741}" type="datetimeFigureOut">
              <a:rPr lang="it-IT" smtClean="0"/>
              <a:pPr/>
              <a:t>29/01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7492" y="33366432"/>
            <a:ext cx="850499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30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7483" y="33366432"/>
            <a:ext cx="5669994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30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B01F8B-3E4E-485A-B64A-0704B318225B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978140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519995" rtl="0" eaLnBrk="1" latinLnBrk="0" hangingPunct="1">
        <a:lnSpc>
          <a:spcPct val="90000"/>
        </a:lnSpc>
        <a:spcBef>
          <a:spcPct val="0"/>
        </a:spcBef>
        <a:buNone/>
        <a:defRPr sz="1212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29999" indent="-629999" algn="l" defTabSz="2519995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7717" kern="1200">
          <a:solidFill>
            <a:schemeClr val="tx1"/>
          </a:solidFill>
          <a:latin typeface="+mn-lt"/>
          <a:ea typeface="+mn-ea"/>
          <a:cs typeface="+mn-cs"/>
        </a:defRPr>
      </a:lvl1pPr>
      <a:lvl2pPr marL="188999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2pPr>
      <a:lvl3pPr marL="314999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3pPr>
      <a:lvl4pPr marL="440999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66998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92998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818998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944998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70997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59997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2pPr>
      <a:lvl3pPr marL="2519995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03999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299987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7559985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8819982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07998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magine 25">
            <a:extLst>
              <a:ext uri="{FF2B5EF4-FFF2-40B4-BE49-F238E27FC236}">
                <a16:creationId xmlns:a16="http://schemas.microsoft.com/office/drawing/2014/main" xmlns="" id="{CFE2D9FD-E8B4-EF0F-BCE3-A56EFAAEFA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5158" y="7785040"/>
            <a:ext cx="10246449" cy="6626640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xmlns="" id="{38C82605-F25E-456E-73F0-4159E00598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44335" y="11088500"/>
            <a:ext cx="11216495" cy="667029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29" name="Immagine 28">
            <a:extLst>
              <a:ext uri="{FF2B5EF4-FFF2-40B4-BE49-F238E27FC236}">
                <a16:creationId xmlns:a16="http://schemas.microsoft.com/office/drawing/2014/main" xmlns="" id="{C8FC3826-6F4F-9B49-5FDB-05A8C09DC5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549174" y="3456061"/>
            <a:ext cx="11248516" cy="6468305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</p:pic>
      <p:pic>
        <p:nvPicPr>
          <p:cNvPr id="2054" name="Picture 6">
            <a:extLst>
              <a:ext uri="{FF2B5EF4-FFF2-40B4-BE49-F238E27FC236}">
                <a16:creationId xmlns:a16="http://schemas.microsoft.com/office/drawing/2014/main" xmlns="" id="{20467BE2-F9E1-D219-A5BC-09701D1963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283822" y="28138392"/>
            <a:ext cx="11347596" cy="6236564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>
            <a:extLst>
              <a:ext uri="{FF2B5EF4-FFF2-40B4-BE49-F238E27FC236}">
                <a16:creationId xmlns:a16="http://schemas.microsoft.com/office/drawing/2014/main" xmlns="" id="{E20A3218-22FD-09DC-9D72-567C88AE2E0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283822" y="21695867"/>
            <a:ext cx="11347596" cy="5894649"/>
          </a:xfrm>
          <a:prstGeom prst="rect">
            <a:avLst/>
          </a:prstGeom>
          <a:noFill/>
          <a:ln>
            <a:solidFill>
              <a:srgbClr val="FF9933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>
            <a:extLst>
              <a:ext uri="{FF2B5EF4-FFF2-40B4-BE49-F238E27FC236}">
                <a16:creationId xmlns:a16="http://schemas.microsoft.com/office/drawing/2014/main" xmlns="" id="{0DD0B518-16F7-F902-78F0-7369E33B7A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152400" cy="15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>
            <a:extLst>
              <a:ext uri="{FF2B5EF4-FFF2-40B4-BE49-F238E27FC236}">
                <a16:creationId xmlns:a16="http://schemas.microsoft.com/office/drawing/2014/main" xmlns="" id="{8517C361-10BB-40B8-4B37-05ACBFE40A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35158" y="24112021"/>
            <a:ext cx="10246448" cy="69800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xmlns="" id="{E2D21C97-7FC5-7791-438A-8FE9C067A9BB}"/>
              </a:ext>
            </a:extLst>
          </p:cNvPr>
          <p:cNvSpPr txBox="1"/>
          <p:nvPr/>
        </p:nvSpPr>
        <p:spPr>
          <a:xfrm>
            <a:off x="643690" y="533699"/>
            <a:ext cx="12597062" cy="70788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it-IT" sz="4000" b="1" err="1"/>
              <a:t>Supplementary</a:t>
            </a:r>
            <a:r>
              <a:rPr lang="it-IT" sz="4000" b="1"/>
              <a:t> Figure 1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2125FE04-5FDE-E47C-C0FE-DB8F5E2430A6}"/>
              </a:ext>
            </a:extLst>
          </p:cNvPr>
          <p:cNvSpPr txBox="1"/>
          <p:nvPr/>
        </p:nvSpPr>
        <p:spPr>
          <a:xfrm>
            <a:off x="10315142" y="2517406"/>
            <a:ext cx="293317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0" b="1"/>
              <a:t>Group a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xmlns="" id="{B57388DB-985E-9E80-D430-3BA5CBCA378E}"/>
              </a:ext>
            </a:extLst>
          </p:cNvPr>
          <p:cNvSpPr txBox="1"/>
          <p:nvPr/>
        </p:nvSpPr>
        <p:spPr>
          <a:xfrm>
            <a:off x="835158" y="2159665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A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xmlns="" id="{B424E747-1BBD-13A1-A57C-6454F1F10D6B}"/>
              </a:ext>
            </a:extLst>
          </p:cNvPr>
          <p:cNvSpPr txBox="1"/>
          <p:nvPr/>
        </p:nvSpPr>
        <p:spPr>
          <a:xfrm>
            <a:off x="835158" y="20748674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B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xmlns="" id="{78DC44B0-9567-FBE7-E5B6-8C69211DE9AD}"/>
              </a:ext>
            </a:extLst>
          </p:cNvPr>
          <p:cNvCxnSpPr/>
          <p:nvPr/>
        </p:nvCxnSpPr>
        <p:spPr>
          <a:xfrm>
            <a:off x="7844558" y="12903498"/>
            <a:ext cx="3137706" cy="2977922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xmlns="" id="{B5A4969A-6DCD-CFC7-9E57-BFF192073FEB}"/>
              </a:ext>
            </a:extLst>
          </p:cNvPr>
          <p:cNvCxnSpPr>
            <a:cxnSpLocks/>
          </p:cNvCxnSpPr>
          <p:nvPr/>
        </p:nvCxnSpPr>
        <p:spPr>
          <a:xfrm flipV="1">
            <a:off x="5029117" y="6721956"/>
            <a:ext cx="6211653" cy="1570086"/>
          </a:xfrm>
          <a:prstGeom prst="straightConnector1">
            <a:avLst/>
          </a:prstGeom>
          <a:ln w="57150">
            <a:solidFill>
              <a:srgbClr val="FF9933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4069A0F-9F3F-4326-4BD2-939BFEB36017}"/>
              </a:ext>
            </a:extLst>
          </p:cNvPr>
          <p:cNvSpPr txBox="1"/>
          <p:nvPr/>
        </p:nvSpPr>
        <p:spPr>
          <a:xfrm rot="16200000">
            <a:off x="9749755" y="24396328"/>
            <a:ext cx="3671787" cy="5232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800" b="1">
                <a:latin typeface="Arial"/>
                <a:cs typeface="Arial"/>
              </a:rPr>
              <a:t>Number of </a:t>
            </a:r>
            <a:r>
              <a:rPr lang="en-US" sz="2800" b="1" err="1">
                <a:latin typeface="Arial"/>
                <a:cs typeface="Arial"/>
              </a:rPr>
              <a:t>dmCpGs</a:t>
            </a:r>
            <a:endParaRPr lang="en-US" sz="2800" b="1">
              <a:latin typeface="Arial"/>
              <a:cs typeface="Arial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F95435A-6331-603E-2A50-9816C4D9A279}"/>
              </a:ext>
            </a:extLst>
          </p:cNvPr>
          <p:cNvSpPr txBox="1"/>
          <p:nvPr/>
        </p:nvSpPr>
        <p:spPr>
          <a:xfrm rot="16200000">
            <a:off x="9672136" y="31017257"/>
            <a:ext cx="3671787" cy="5232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800" b="1">
                <a:latin typeface="Arial"/>
                <a:cs typeface="Arial"/>
              </a:rPr>
              <a:t>Number of </a:t>
            </a:r>
            <a:r>
              <a:rPr lang="en-US" sz="2800" b="1" err="1">
                <a:latin typeface="Arial"/>
                <a:cs typeface="Arial"/>
              </a:rPr>
              <a:t>dmCpGs</a:t>
            </a:r>
            <a:endParaRPr lang="en-US" sz="2800" b="1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16383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xmlns="" id="{2730AB41-AB80-3414-51A8-D084BE3829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8905" y="7818375"/>
            <a:ext cx="10246449" cy="662664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xmlns="" id="{FFD0AA9A-B3F1-8335-57C4-8CC07FB81C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54064" y="11317083"/>
            <a:ext cx="10809605" cy="6350226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xmlns="" id="{7CF99E4A-4DAF-9031-C4C4-61A6D17D61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54064" y="4319337"/>
            <a:ext cx="10809605" cy="6358822"/>
          </a:xfrm>
          <a:prstGeom prst="rect">
            <a:avLst/>
          </a:prstGeom>
          <a:ln>
            <a:solidFill>
              <a:schemeClr val="accent2"/>
            </a:solidFill>
          </a:ln>
        </p:spPr>
      </p:pic>
      <p:pic>
        <p:nvPicPr>
          <p:cNvPr id="3073" name="Picture 1">
            <a:extLst>
              <a:ext uri="{FF2B5EF4-FFF2-40B4-BE49-F238E27FC236}">
                <a16:creationId xmlns:a16="http://schemas.microsoft.com/office/drawing/2014/main" xmlns="" id="{BE142B40-8455-EEDF-9832-46092F384E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38905" y="24388991"/>
            <a:ext cx="10246449" cy="7193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xmlns="" id="{7D4125D6-DE17-1518-C76F-601FCFBFF117}"/>
              </a:ext>
            </a:extLst>
          </p:cNvPr>
          <p:cNvSpPr txBox="1"/>
          <p:nvPr/>
        </p:nvSpPr>
        <p:spPr>
          <a:xfrm>
            <a:off x="446489" y="366441"/>
            <a:ext cx="12597062" cy="70788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it-IT" sz="4000" b="1" err="1"/>
              <a:t>Supplementary</a:t>
            </a:r>
            <a:r>
              <a:rPr lang="it-IT" sz="4000" b="1"/>
              <a:t> Figure 2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90FF9E3A-8F8F-9531-CD82-2DB3BFD08EA3}"/>
              </a:ext>
            </a:extLst>
          </p:cNvPr>
          <p:cNvSpPr txBox="1"/>
          <p:nvPr/>
        </p:nvSpPr>
        <p:spPr>
          <a:xfrm>
            <a:off x="9894524" y="2857921"/>
            <a:ext cx="295882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0" b="1"/>
              <a:t>Group b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1840584E-E6C5-8920-089E-AA58592394C4}"/>
              </a:ext>
            </a:extLst>
          </p:cNvPr>
          <p:cNvSpPr txBox="1"/>
          <p:nvPr/>
        </p:nvSpPr>
        <p:spPr>
          <a:xfrm>
            <a:off x="738905" y="2159665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A6A2E30F-3505-B965-2826-EE8772335677}"/>
              </a:ext>
            </a:extLst>
          </p:cNvPr>
          <p:cNvSpPr txBox="1"/>
          <p:nvPr/>
        </p:nvSpPr>
        <p:spPr>
          <a:xfrm>
            <a:off x="738905" y="20748674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B</a:t>
            </a:r>
          </a:p>
        </p:txBody>
      </p:sp>
      <p:grpSp>
        <p:nvGrpSpPr>
          <p:cNvPr id="15" name="Gruppo 14">
            <a:extLst>
              <a:ext uri="{FF2B5EF4-FFF2-40B4-BE49-F238E27FC236}">
                <a16:creationId xmlns:a16="http://schemas.microsoft.com/office/drawing/2014/main" xmlns="" id="{4AFEE778-BC38-B479-75A7-6AD10EDE834A}"/>
              </a:ext>
            </a:extLst>
          </p:cNvPr>
          <p:cNvGrpSpPr/>
          <p:nvPr/>
        </p:nvGrpSpPr>
        <p:grpSpPr>
          <a:xfrm>
            <a:off x="11324039" y="27711033"/>
            <a:ext cx="11015079" cy="5555941"/>
            <a:chOff x="11324039" y="22278429"/>
            <a:chExt cx="11015079" cy="5555941"/>
          </a:xfrm>
        </p:grpSpPr>
        <p:pic>
          <p:nvPicPr>
            <p:cNvPr id="3074" name="Picture 2">
              <a:extLst>
                <a:ext uri="{FF2B5EF4-FFF2-40B4-BE49-F238E27FC236}">
                  <a16:creationId xmlns:a16="http://schemas.microsoft.com/office/drawing/2014/main" xmlns="" id="{99DFA977-70AC-6E3A-F875-7193024AE89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45128" y="22278429"/>
              <a:ext cx="10893990" cy="555594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FCF0A08A-4C29-126A-9A76-DA6A8C180103}"/>
                </a:ext>
              </a:extLst>
            </p:cNvPr>
            <p:cNvSpPr txBox="1"/>
            <p:nvPr/>
          </p:nvSpPr>
          <p:spPr>
            <a:xfrm rot="16200000">
              <a:off x="9749755" y="24876688"/>
              <a:ext cx="3671787" cy="52322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2800" b="1">
                  <a:latin typeface="Arial"/>
                  <a:cs typeface="Arial"/>
                </a:rPr>
                <a:t>Number of </a:t>
              </a:r>
              <a:r>
                <a:rPr lang="en-US" sz="2800" b="1" err="1">
                  <a:latin typeface="Arial"/>
                  <a:cs typeface="Arial"/>
                </a:rPr>
                <a:t>dmCpGs</a:t>
              </a:r>
              <a:endParaRPr lang="en-US" sz="2800" b="1">
                <a:latin typeface="Arial"/>
                <a:cs typeface="Arial"/>
              </a:endParaRPr>
            </a:p>
          </p:txBody>
        </p:sp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xmlns="" id="{5F82101A-FBCB-F4F2-5F12-E272BE0DC857}"/>
              </a:ext>
            </a:extLst>
          </p:cNvPr>
          <p:cNvGrpSpPr/>
          <p:nvPr/>
        </p:nvGrpSpPr>
        <p:grpSpPr>
          <a:xfrm>
            <a:off x="11413354" y="21857002"/>
            <a:ext cx="10893990" cy="5555941"/>
            <a:chOff x="11445128" y="28401543"/>
            <a:chExt cx="10893990" cy="5555941"/>
          </a:xfrm>
        </p:grpSpPr>
        <p:pic>
          <p:nvPicPr>
            <p:cNvPr id="3075" name="Picture 3">
              <a:extLst>
                <a:ext uri="{FF2B5EF4-FFF2-40B4-BE49-F238E27FC236}">
                  <a16:creationId xmlns:a16="http://schemas.microsoft.com/office/drawing/2014/main" xmlns="" id="{27EFFD25-9982-0011-4684-7EB54518CD3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45128" y="28401543"/>
              <a:ext cx="10893990" cy="5555941"/>
            </a:xfrm>
            <a:prstGeom prst="rect">
              <a:avLst/>
            </a:prstGeom>
            <a:noFill/>
            <a:ln>
              <a:solidFill>
                <a:srgbClr val="FF9933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E5CF7DFD-E264-B178-C79A-AE1F06075F88}"/>
                </a:ext>
              </a:extLst>
            </p:cNvPr>
            <p:cNvSpPr txBox="1"/>
            <p:nvPr/>
          </p:nvSpPr>
          <p:spPr>
            <a:xfrm rot="16200000">
              <a:off x="9880267" y="30929224"/>
              <a:ext cx="3671787" cy="52322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2800" b="1">
                  <a:latin typeface="Arial"/>
                  <a:cs typeface="Arial"/>
                </a:rPr>
                <a:t>Number of </a:t>
              </a:r>
              <a:r>
                <a:rPr lang="en-US" sz="2800" b="1" err="1">
                  <a:latin typeface="Arial"/>
                  <a:cs typeface="Arial"/>
                </a:rPr>
                <a:t>dmCpGs</a:t>
              </a:r>
              <a:endParaRPr lang="en-US" sz="2800" b="1">
                <a:latin typeface="Arial"/>
                <a:cs typeface="Arial"/>
              </a:endParaRPr>
            </a:p>
          </p:txBody>
        </p:sp>
      </p:grpSp>
      <p:cxnSp>
        <p:nvCxnSpPr>
          <p:cNvPr id="12" name="Straight Arrow Connector 6">
            <a:extLst>
              <a:ext uri="{FF2B5EF4-FFF2-40B4-BE49-F238E27FC236}">
                <a16:creationId xmlns:a16="http://schemas.microsoft.com/office/drawing/2014/main" xmlns="" id="{11B3ECEB-9806-E1BB-C073-E204EFB142DB}"/>
              </a:ext>
            </a:extLst>
          </p:cNvPr>
          <p:cNvCxnSpPr>
            <a:cxnSpLocks/>
          </p:cNvCxnSpPr>
          <p:nvPr/>
        </p:nvCxnSpPr>
        <p:spPr>
          <a:xfrm flipV="1">
            <a:off x="5029117" y="6721956"/>
            <a:ext cx="6211653" cy="1570086"/>
          </a:xfrm>
          <a:prstGeom prst="straightConnector1">
            <a:avLst/>
          </a:prstGeom>
          <a:ln w="57150">
            <a:solidFill>
              <a:srgbClr val="FF9933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">
            <a:extLst>
              <a:ext uri="{FF2B5EF4-FFF2-40B4-BE49-F238E27FC236}">
                <a16:creationId xmlns:a16="http://schemas.microsoft.com/office/drawing/2014/main" xmlns="" id="{D6268132-4530-9861-F41B-E03ED985C481}"/>
              </a:ext>
            </a:extLst>
          </p:cNvPr>
          <p:cNvCxnSpPr/>
          <p:nvPr/>
        </p:nvCxnSpPr>
        <p:spPr>
          <a:xfrm>
            <a:off x="7844558" y="12903498"/>
            <a:ext cx="3137706" cy="2977922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639010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7AB24153-77EE-8881-E2D7-64F9A4D5EAC8}"/>
              </a:ext>
            </a:extLst>
          </p:cNvPr>
          <p:cNvSpPr txBox="1"/>
          <p:nvPr/>
        </p:nvSpPr>
        <p:spPr>
          <a:xfrm>
            <a:off x="959190" y="437151"/>
            <a:ext cx="5707075" cy="707886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sz="4000" b="1" err="1"/>
              <a:t>Supplementary</a:t>
            </a:r>
            <a:r>
              <a:rPr lang="it-IT" sz="4000" b="1"/>
              <a:t> Figure 3</a:t>
            </a:r>
          </a:p>
        </p:txBody>
      </p:sp>
      <p:sp>
        <p:nvSpPr>
          <p:cNvPr id="5" name="CasellaDiTesto 22">
            <a:extLst>
              <a:ext uri="{FF2B5EF4-FFF2-40B4-BE49-F238E27FC236}">
                <a16:creationId xmlns:a16="http://schemas.microsoft.com/office/drawing/2014/main" xmlns="" id="{E841296C-4B9B-830E-D249-23CE73FBA6C0}"/>
              </a:ext>
            </a:extLst>
          </p:cNvPr>
          <p:cNvSpPr txBox="1"/>
          <p:nvPr/>
        </p:nvSpPr>
        <p:spPr>
          <a:xfrm>
            <a:off x="10779714" y="19432678"/>
            <a:ext cx="691848" cy="2100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765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" name="Immagine 2" descr="Immagine che contiene testo, schermata, diagramma, linea&#10;&#10;Descrizione generata automaticamente">
            <a:extLst>
              <a:ext uri="{FF2B5EF4-FFF2-40B4-BE49-F238E27FC236}">
                <a16:creationId xmlns:a16="http://schemas.microsoft.com/office/drawing/2014/main" xmlns="" id="{A0D5ACAD-6FD7-0341-1703-0CD28BE782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71562" y="11036447"/>
            <a:ext cx="10727227" cy="6489251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4" name="Immagine 3" descr="Immagine che contiene testo, diagramma, schermata, Diagramma&#10;&#10;Descrizione generata automaticamente">
            <a:extLst>
              <a:ext uri="{FF2B5EF4-FFF2-40B4-BE49-F238E27FC236}">
                <a16:creationId xmlns:a16="http://schemas.microsoft.com/office/drawing/2014/main" xmlns="" id="{1E4250FD-7998-9A47-89AF-BEB2933CE5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72621" y="4062183"/>
            <a:ext cx="10739428" cy="6489251"/>
          </a:xfrm>
          <a:prstGeom prst="rect">
            <a:avLst/>
          </a:prstGeom>
          <a:ln>
            <a:solidFill>
              <a:schemeClr val="accent2"/>
            </a:solidFill>
          </a:ln>
        </p:spPr>
      </p:pic>
      <p:pic>
        <p:nvPicPr>
          <p:cNvPr id="13" name="Immagine 12" descr="Immagine che contiene testo, schermata, logo, Elementi grafici&#10;&#10;Descrizione generata automaticamente">
            <a:extLst>
              <a:ext uri="{FF2B5EF4-FFF2-40B4-BE49-F238E27FC236}">
                <a16:creationId xmlns:a16="http://schemas.microsoft.com/office/drawing/2014/main" xmlns="" id="{6431EF51-C4F2-9F07-85C8-76FA71CA37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3264" y="7661430"/>
            <a:ext cx="10246449" cy="6626640"/>
          </a:xfrm>
          <a:prstGeom prst="rect">
            <a:avLst/>
          </a:prstGeom>
        </p:spPr>
      </p:pic>
      <p:pic>
        <p:nvPicPr>
          <p:cNvPr id="1025" name="Picture 1">
            <a:extLst>
              <a:ext uri="{FF2B5EF4-FFF2-40B4-BE49-F238E27FC236}">
                <a16:creationId xmlns:a16="http://schemas.microsoft.com/office/drawing/2014/main" xmlns="" id="{BB0069F2-20BC-4AD6-985E-854826FD44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33264" y="24422982"/>
            <a:ext cx="10366147" cy="66021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539EE3CA-BB9F-1354-162A-85F5EA0567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504219" y="22387071"/>
            <a:ext cx="10397939" cy="5219309"/>
          </a:xfrm>
          <a:prstGeom prst="rect">
            <a:avLst/>
          </a:prstGeom>
          <a:solidFill>
            <a:schemeClr val="accent2"/>
          </a:solidFill>
          <a:ln>
            <a:solidFill>
              <a:srgbClr val="FF9933"/>
            </a:solidFill>
          </a:ln>
        </p:spPr>
      </p:pic>
      <p:pic>
        <p:nvPicPr>
          <p:cNvPr id="1027" name="Picture 3">
            <a:extLst>
              <a:ext uri="{FF2B5EF4-FFF2-40B4-BE49-F238E27FC236}">
                <a16:creationId xmlns:a16="http://schemas.microsoft.com/office/drawing/2014/main" xmlns="" id="{8064DBFE-CD9E-79D1-16F8-09D5696AFD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532831" y="28030358"/>
            <a:ext cx="10444776" cy="5618666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93C14AC9-FF6D-B1EE-5254-354BF712461F}"/>
              </a:ext>
            </a:extLst>
          </p:cNvPr>
          <p:cNvSpPr txBox="1"/>
          <p:nvPr/>
        </p:nvSpPr>
        <p:spPr>
          <a:xfrm>
            <a:off x="10271719" y="2857877"/>
            <a:ext cx="292996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0" b="1"/>
              <a:t>Group c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FD28A142-4474-33D0-A81D-DB0F03F33E15}"/>
              </a:ext>
            </a:extLst>
          </p:cNvPr>
          <p:cNvSpPr txBox="1"/>
          <p:nvPr/>
        </p:nvSpPr>
        <p:spPr>
          <a:xfrm>
            <a:off x="533264" y="2159665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90AF9CF8-38CC-3004-68B2-349E00BC0C07}"/>
              </a:ext>
            </a:extLst>
          </p:cNvPr>
          <p:cNvSpPr txBox="1"/>
          <p:nvPr/>
        </p:nvSpPr>
        <p:spPr>
          <a:xfrm>
            <a:off x="1587516" y="20748674"/>
            <a:ext cx="772963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sz="4000" b="1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5FEDF361-938B-AE92-9E87-4330BB57AFFA}"/>
              </a:ext>
            </a:extLst>
          </p:cNvPr>
          <p:cNvSpPr txBox="1"/>
          <p:nvPr/>
        </p:nvSpPr>
        <p:spPr>
          <a:xfrm rot="16200000">
            <a:off x="9973907" y="25004769"/>
            <a:ext cx="3607746" cy="5232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800" b="1">
                <a:latin typeface="Arial"/>
                <a:cs typeface="Arial"/>
              </a:rPr>
              <a:t>Number of </a:t>
            </a:r>
            <a:r>
              <a:rPr lang="en-US" sz="2800" b="1" err="1">
                <a:latin typeface="Arial"/>
                <a:cs typeface="Arial"/>
              </a:rPr>
              <a:t>dmCpGs</a:t>
            </a:r>
            <a:endParaRPr lang="en-US" sz="2800" b="1">
              <a:latin typeface="Arial"/>
              <a:cs typeface="Arial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530400C8-D61C-772E-5DB8-25A01453B81D}"/>
              </a:ext>
            </a:extLst>
          </p:cNvPr>
          <p:cNvSpPr txBox="1"/>
          <p:nvPr/>
        </p:nvSpPr>
        <p:spPr>
          <a:xfrm rot="16200000">
            <a:off x="9912379" y="30769089"/>
            <a:ext cx="3607746" cy="5232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800" b="1">
                <a:latin typeface="Arial"/>
                <a:cs typeface="Arial"/>
              </a:rPr>
              <a:t>Number of </a:t>
            </a:r>
            <a:r>
              <a:rPr lang="en-US" sz="2800" b="1" err="1">
                <a:latin typeface="Arial"/>
                <a:cs typeface="Arial"/>
              </a:rPr>
              <a:t>dmCpGs</a:t>
            </a:r>
            <a:endParaRPr lang="en-US" sz="2800" b="1">
              <a:latin typeface="Arial"/>
              <a:cs typeface="Arial"/>
            </a:endParaRPr>
          </a:p>
        </p:txBody>
      </p:sp>
      <p:cxnSp>
        <p:nvCxnSpPr>
          <p:cNvPr id="9" name="Straight Arrow Connector 6">
            <a:extLst>
              <a:ext uri="{FF2B5EF4-FFF2-40B4-BE49-F238E27FC236}">
                <a16:creationId xmlns:a16="http://schemas.microsoft.com/office/drawing/2014/main" xmlns="" id="{B2128DD0-002F-1F0A-FFC2-F5C6D0C84DC3}"/>
              </a:ext>
            </a:extLst>
          </p:cNvPr>
          <p:cNvCxnSpPr>
            <a:cxnSpLocks/>
          </p:cNvCxnSpPr>
          <p:nvPr/>
        </p:nvCxnSpPr>
        <p:spPr>
          <a:xfrm flipV="1">
            <a:off x="5029117" y="6721956"/>
            <a:ext cx="6211653" cy="1570086"/>
          </a:xfrm>
          <a:prstGeom prst="straightConnector1">
            <a:avLst/>
          </a:prstGeom>
          <a:ln w="57150">
            <a:solidFill>
              <a:srgbClr val="FF9933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">
            <a:extLst>
              <a:ext uri="{FF2B5EF4-FFF2-40B4-BE49-F238E27FC236}">
                <a16:creationId xmlns:a16="http://schemas.microsoft.com/office/drawing/2014/main" xmlns="" id="{877E60CA-A4C9-A1FF-A150-43F6F324C1B4}"/>
              </a:ext>
            </a:extLst>
          </p:cNvPr>
          <p:cNvCxnSpPr/>
          <p:nvPr/>
        </p:nvCxnSpPr>
        <p:spPr>
          <a:xfrm>
            <a:off x="7844558" y="12903498"/>
            <a:ext cx="3137706" cy="2977922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637836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Personalizzato</PresentationFormat>
  <Paragraphs>25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Diapositiva 1</vt:lpstr>
      <vt:lpstr>Diapositiva 2</vt:lpstr>
      <vt:lpstr>Diapositiva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ana De Luca</dc:creator>
  <cp:lastModifiedBy>Ilaria Laurenzana</cp:lastModifiedBy>
  <cp:revision>151</cp:revision>
  <dcterms:created xsi:type="dcterms:W3CDTF">2024-06-24T07:46:32Z</dcterms:created>
  <dcterms:modified xsi:type="dcterms:W3CDTF">2025-01-29T18:34:45Z</dcterms:modified>
</cp:coreProperties>
</file>